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1.xml.rels" ContentType="application/vnd.openxmlformats-package.relationships+xml"/>
  <Override PartName="/ppt/notesSlides/notesSlide1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media/image5.png" ContentType="image/png"/>
  <Override PartName="/ppt/media/image6.png" ContentType="image/png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</p:sldIdLst>
  <p:sldSz cx="12801600" cy="128016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6858000" cy="91440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2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hdr"/>
          </p:nvPr>
        </p:nvSpPr>
        <p:spPr>
          <a:xfrm>
            <a:off x="-36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730080"/>
                <a:tab algn="l" pos="1460520"/>
                <a:tab algn="l" pos="2190600"/>
                <a:tab algn="l" pos="2921040"/>
                <a:tab algn="l" pos="3651120"/>
                <a:tab algn="l" pos="4381560"/>
                <a:tab algn="l" pos="5111640"/>
                <a:tab algn="l" pos="5842080"/>
                <a:tab algn="l" pos="6572160"/>
                <a:tab algn="l" pos="7302600"/>
                <a:tab algn="l" pos="8032680"/>
                <a:tab algn="l" pos="8763120"/>
                <a:tab algn="l" pos="9493200"/>
                <a:tab algn="l" pos="10223640"/>
                <a:tab algn="l" pos="10953720"/>
              </a:tabLst>
            </a:pPr>
            <a:endParaRPr b="0" lang="en-US" sz="2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dt" idx="4"/>
          </p:nvPr>
        </p:nvSpPr>
        <p:spPr>
          <a:xfrm>
            <a:off x="388440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730080"/>
                <a:tab algn="l" pos="1460520"/>
                <a:tab algn="l" pos="2190600"/>
                <a:tab algn="l" pos="2921040"/>
                <a:tab algn="l" pos="3651120"/>
                <a:tab algn="l" pos="4381560"/>
                <a:tab algn="l" pos="5111640"/>
                <a:tab algn="l" pos="5842080"/>
                <a:tab algn="l" pos="6572160"/>
                <a:tab algn="l" pos="7302600"/>
                <a:tab algn="l" pos="8032680"/>
                <a:tab algn="l" pos="8763120"/>
                <a:tab algn="l" pos="9493200"/>
                <a:tab algn="l" pos="10223640"/>
                <a:tab algn="l" pos="10953720"/>
              </a:tabLst>
              <a:defRPr b="0" lang="en-US" sz="12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730080"/>
                <a:tab algn="l" pos="1460520"/>
                <a:tab algn="l" pos="2190600"/>
                <a:tab algn="l" pos="2921040"/>
                <a:tab algn="l" pos="3651120"/>
                <a:tab algn="l" pos="4381560"/>
                <a:tab algn="l" pos="5111640"/>
                <a:tab algn="l" pos="5842080"/>
                <a:tab algn="l" pos="6572160"/>
                <a:tab algn="l" pos="7302600"/>
                <a:tab algn="l" pos="8032680"/>
                <a:tab algn="l" pos="8763120"/>
                <a:tab algn="l" pos="9493200"/>
                <a:tab algn="l" pos="10223640"/>
                <a:tab algn="l" pos="1095372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sldImg"/>
          </p:nvPr>
        </p:nvSpPr>
        <p:spPr>
          <a:xfrm>
            <a:off x="1715760" y="685440"/>
            <a:ext cx="3427560" cy="342900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730080"/>
                <a:tab algn="l" pos="1460520"/>
                <a:tab algn="l" pos="2190600"/>
                <a:tab algn="l" pos="2921040"/>
                <a:tab algn="l" pos="3651120"/>
                <a:tab algn="l" pos="4381560"/>
                <a:tab algn="l" pos="5111640"/>
                <a:tab algn="l" pos="5842080"/>
                <a:tab algn="l" pos="6572160"/>
                <a:tab algn="l" pos="7302600"/>
                <a:tab algn="l" pos="8032680"/>
                <a:tab algn="l" pos="8763120"/>
                <a:tab algn="l" pos="9493200"/>
                <a:tab algn="l" pos="10223640"/>
                <a:tab algn="l" pos="10953720"/>
              </a:tabLst>
            </a:pPr>
            <a:r>
              <a:rPr b="0" lang="en-US" sz="7000" spc="-1" strike="noStrike">
                <a:solidFill>
                  <a:srgbClr val="000000"/>
                </a:solidFill>
                <a:latin typeface="Calibri"/>
              </a:rPr>
              <a:t>Click to move the slide</a:t>
            </a:r>
            <a:endParaRPr b="0" lang="en-US" sz="7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spcBef>
                <a:spcPts val="488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300" spc="-1" strike="noStrike">
                <a:solidFill>
                  <a:srgbClr val="000000"/>
                </a:solidFill>
                <a:latin typeface="Calibri"/>
              </a:rPr>
              <a:t>Click to edit the notes format</a:t>
            </a:r>
            <a:endParaRPr b="0" lang="en-US" sz="1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5"/>
          </p:nvPr>
        </p:nvSpPr>
        <p:spPr>
          <a:xfrm>
            <a:off x="-3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730080"/>
                <a:tab algn="l" pos="1460520"/>
                <a:tab algn="l" pos="2190600"/>
                <a:tab algn="l" pos="2921040"/>
                <a:tab algn="l" pos="3651120"/>
                <a:tab algn="l" pos="4381560"/>
                <a:tab algn="l" pos="5111640"/>
                <a:tab algn="l" pos="5842080"/>
                <a:tab algn="l" pos="6572160"/>
                <a:tab algn="l" pos="7302600"/>
                <a:tab algn="l" pos="8032680"/>
                <a:tab algn="l" pos="8763120"/>
                <a:tab algn="l" pos="9493200"/>
                <a:tab algn="l" pos="10223640"/>
                <a:tab algn="l" pos="10953720"/>
              </a:tabLst>
            </a:pPr>
            <a:endParaRPr b="0" lang="en-US" sz="2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6"/>
          </p:nvPr>
        </p:nvSpPr>
        <p:spPr>
          <a:xfrm>
            <a:off x="388440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 algn="r">
              <a:buNone/>
              <a:tabLst>
                <a:tab algn="l" pos="0"/>
                <a:tab algn="l" pos="730080"/>
                <a:tab algn="l" pos="1460520"/>
                <a:tab algn="l" pos="2190600"/>
                <a:tab algn="l" pos="2921040"/>
                <a:tab algn="l" pos="3651120"/>
                <a:tab algn="l" pos="4381560"/>
                <a:tab algn="l" pos="5111640"/>
                <a:tab algn="l" pos="5842080"/>
                <a:tab algn="l" pos="6572160"/>
                <a:tab algn="l" pos="7302600"/>
                <a:tab algn="l" pos="8032680"/>
                <a:tab algn="l" pos="8763120"/>
                <a:tab algn="l" pos="9493200"/>
                <a:tab algn="l" pos="10223640"/>
                <a:tab algn="l" pos="10953720"/>
              </a:tabLst>
              <a:defRPr b="0" lang="en-US" sz="12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730080"/>
                <a:tab algn="l" pos="1460520"/>
                <a:tab algn="l" pos="2190600"/>
                <a:tab algn="l" pos="2921040"/>
                <a:tab algn="l" pos="3651120"/>
                <a:tab algn="l" pos="4381560"/>
                <a:tab algn="l" pos="5111640"/>
                <a:tab algn="l" pos="5842080"/>
                <a:tab algn="l" pos="6572160"/>
                <a:tab algn="l" pos="7302600"/>
                <a:tab algn="l" pos="8032680"/>
                <a:tab algn="l" pos="8763120"/>
                <a:tab algn="l" pos="9493200"/>
                <a:tab algn="l" pos="10223640"/>
                <a:tab algn="l" pos="10953720"/>
              </a:tabLst>
            </a:pPr>
            <a:fld id="{D0771A02-0215-4614-88BF-A69E3BFE7397}" type="slidenum">
              <a:rPr b="0" lang="en-US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.xml.rels><?xml version="1.0" encoding="UTF-8"?>
<Relationships xmlns="http://schemas.openxmlformats.org/package/2006/relationships"><Relationship Id="rId1" Type="http://schemas.openxmlformats.org/officeDocument/2006/relationships/slide" Target="../slides/slide1.xml"/>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4" name="PlaceHolder 1"/>
          <p:cNvSpPr>
            <a:spLocks noGrp="1"/>
          </p:cNvSpPr>
          <p:nvPr>
            <p:ph type="sldImg"/>
          </p:nvPr>
        </p:nvSpPr>
        <p:spPr>
          <a:xfrm>
            <a:off x="1716120" y="685800"/>
            <a:ext cx="3427560" cy="3429000"/>
          </a:xfrm>
          <a:prstGeom prst="rect">
            <a:avLst/>
          </a:prstGeom>
          <a:ln w="0">
            <a:noFill/>
          </a:ln>
        </p:spPr>
      </p:sp>
      <p:sp>
        <p:nvSpPr>
          <p:cNvPr id="125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88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6" name="Slide Number Placeholder 3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730080"/>
                <a:tab algn="l" pos="1460520"/>
                <a:tab algn="l" pos="2190600"/>
                <a:tab algn="l" pos="2921040"/>
                <a:tab algn="l" pos="3651120"/>
                <a:tab algn="l" pos="4381560"/>
                <a:tab algn="l" pos="5111640"/>
                <a:tab algn="l" pos="5842080"/>
                <a:tab algn="l" pos="6572160"/>
                <a:tab algn="l" pos="7302600"/>
                <a:tab algn="l" pos="8032680"/>
                <a:tab algn="l" pos="8763120"/>
                <a:tab algn="l" pos="9493200"/>
                <a:tab algn="l" pos="10223640"/>
                <a:tab algn="l" pos="10953720"/>
              </a:tabLst>
            </a:pPr>
            <a:fld id="{526B93CF-73C9-4264-A16A-988403E84D8A}" type="slidenum">
              <a:rPr b="0" lang="en-US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0FEA379-97CE-43DE-921D-76072DC7A207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639720" y="512280"/>
            <a:ext cx="11522160" cy="2133720"/>
          </a:xfrm>
          <a:prstGeom prst="rect">
            <a:avLst/>
          </a:prstGeom>
          <a:noFill/>
          <a:ln w="0">
            <a:noFill/>
          </a:ln>
        </p:spPr>
        <p:txBody>
          <a:bodyPr lIns="146160" rIns="146160" tIns="73080" bIns="73080" anchor="ctr">
            <a:noAutofit/>
          </a:bodyPr>
          <a:p>
            <a:pPr indent="0" algn="ctr">
              <a:buNone/>
              <a:tabLst>
                <a:tab algn="l" pos="0"/>
                <a:tab algn="l" pos="730080"/>
                <a:tab algn="l" pos="1460520"/>
                <a:tab algn="l" pos="2190600"/>
                <a:tab algn="l" pos="2921040"/>
                <a:tab algn="l" pos="3651120"/>
                <a:tab algn="l" pos="4381560"/>
                <a:tab algn="l" pos="5111640"/>
                <a:tab algn="l" pos="5842080"/>
                <a:tab algn="l" pos="6572160"/>
                <a:tab algn="l" pos="7302600"/>
                <a:tab algn="l" pos="8032680"/>
                <a:tab algn="l" pos="8763120"/>
                <a:tab algn="l" pos="9493200"/>
                <a:tab algn="l" pos="10223640"/>
                <a:tab algn="l" pos="10953720"/>
              </a:tabLst>
            </a:pPr>
            <a:endParaRPr b="0" lang="en-US" sz="7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639720" y="2987640"/>
            <a:ext cx="11522160" cy="4029120"/>
          </a:xfrm>
          <a:prstGeom prst="rect">
            <a:avLst/>
          </a:prstGeom>
          <a:noFill/>
          <a:ln w="0">
            <a:noFill/>
          </a:ln>
        </p:spPr>
        <p:txBody>
          <a:bodyPr lIns="146160" rIns="146160" tIns="73080" bIns="73080" anchor="t">
            <a:normAutofit/>
          </a:bodyPr>
          <a:p>
            <a:pPr indent="0">
              <a:spcBef>
                <a:spcPts val="1276"/>
              </a:spcBef>
              <a:buNone/>
              <a:tabLst>
                <a:tab algn="l" pos="730080"/>
                <a:tab algn="l" pos="1460520"/>
                <a:tab algn="l" pos="2190600"/>
                <a:tab algn="l" pos="2921040"/>
                <a:tab algn="l" pos="3651120"/>
                <a:tab algn="l" pos="4381560"/>
                <a:tab algn="l" pos="5111640"/>
                <a:tab algn="l" pos="5842080"/>
                <a:tab algn="l" pos="6572160"/>
                <a:tab algn="l" pos="7302600"/>
                <a:tab algn="l" pos="8032680"/>
                <a:tab algn="l" pos="8763120"/>
                <a:tab algn="l" pos="9493200"/>
                <a:tab algn="l" pos="10223640"/>
                <a:tab algn="l" pos="10953720"/>
              </a:tabLst>
            </a:pPr>
            <a:endParaRPr b="0" lang="en-US" sz="5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639720" y="7399800"/>
            <a:ext cx="11522160" cy="4029120"/>
          </a:xfrm>
          <a:prstGeom prst="rect">
            <a:avLst/>
          </a:prstGeom>
          <a:noFill/>
          <a:ln w="0">
            <a:noFill/>
          </a:ln>
        </p:spPr>
        <p:txBody>
          <a:bodyPr lIns="146160" rIns="146160" tIns="73080" bIns="73080" anchor="t">
            <a:normAutofit/>
          </a:bodyPr>
          <a:p>
            <a:pPr indent="0">
              <a:spcBef>
                <a:spcPts val="1276"/>
              </a:spcBef>
              <a:buNone/>
              <a:tabLst>
                <a:tab algn="l" pos="730080"/>
                <a:tab algn="l" pos="1460520"/>
                <a:tab algn="l" pos="2190600"/>
                <a:tab algn="l" pos="2921040"/>
                <a:tab algn="l" pos="3651120"/>
                <a:tab algn="l" pos="4381560"/>
                <a:tab algn="l" pos="5111640"/>
                <a:tab algn="l" pos="5842080"/>
                <a:tab algn="l" pos="6572160"/>
                <a:tab algn="l" pos="7302600"/>
                <a:tab algn="l" pos="8032680"/>
                <a:tab algn="l" pos="8763120"/>
                <a:tab algn="l" pos="9493200"/>
                <a:tab algn="l" pos="10223640"/>
                <a:tab algn="l" pos="10953720"/>
              </a:tabLst>
            </a:pPr>
            <a:endParaRPr b="0" lang="en-US" sz="5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D23D4FF-31E6-41B7-9C32-8F7F5614DF8E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639720" y="512280"/>
            <a:ext cx="11522160" cy="2133720"/>
          </a:xfrm>
          <a:prstGeom prst="rect">
            <a:avLst/>
          </a:prstGeom>
          <a:noFill/>
          <a:ln w="0">
            <a:noFill/>
          </a:ln>
        </p:spPr>
        <p:txBody>
          <a:bodyPr lIns="146160" rIns="146160" tIns="73080" bIns="73080" anchor="ctr">
            <a:noAutofit/>
          </a:bodyPr>
          <a:p>
            <a:pPr indent="0" algn="ctr">
              <a:buNone/>
              <a:tabLst>
                <a:tab algn="l" pos="0"/>
                <a:tab algn="l" pos="730080"/>
                <a:tab algn="l" pos="1460520"/>
                <a:tab algn="l" pos="2190600"/>
                <a:tab algn="l" pos="2921040"/>
                <a:tab algn="l" pos="3651120"/>
                <a:tab algn="l" pos="4381560"/>
                <a:tab algn="l" pos="5111640"/>
                <a:tab algn="l" pos="5842080"/>
                <a:tab algn="l" pos="6572160"/>
                <a:tab algn="l" pos="7302600"/>
                <a:tab algn="l" pos="8032680"/>
                <a:tab algn="l" pos="8763120"/>
                <a:tab algn="l" pos="9493200"/>
                <a:tab algn="l" pos="10223640"/>
                <a:tab algn="l" pos="10953720"/>
              </a:tabLst>
            </a:pPr>
            <a:endParaRPr b="0" lang="en-US" sz="7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639720" y="2987640"/>
            <a:ext cx="5622480" cy="4029120"/>
          </a:xfrm>
          <a:prstGeom prst="rect">
            <a:avLst/>
          </a:prstGeom>
          <a:noFill/>
          <a:ln w="0">
            <a:noFill/>
          </a:ln>
        </p:spPr>
        <p:txBody>
          <a:bodyPr lIns="146160" rIns="146160" tIns="73080" bIns="73080" anchor="t">
            <a:normAutofit/>
          </a:bodyPr>
          <a:p>
            <a:pPr indent="0">
              <a:spcBef>
                <a:spcPts val="1276"/>
              </a:spcBef>
              <a:buNone/>
              <a:tabLst>
                <a:tab algn="l" pos="730080"/>
                <a:tab algn="l" pos="1460520"/>
                <a:tab algn="l" pos="2190600"/>
                <a:tab algn="l" pos="2921040"/>
                <a:tab algn="l" pos="3651120"/>
                <a:tab algn="l" pos="4381560"/>
                <a:tab algn="l" pos="5111640"/>
                <a:tab algn="l" pos="5842080"/>
                <a:tab algn="l" pos="6572160"/>
                <a:tab algn="l" pos="7302600"/>
                <a:tab algn="l" pos="8032680"/>
                <a:tab algn="l" pos="8763120"/>
                <a:tab algn="l" pos="9493200"/>
                <a:tab algn="l" pos="10223640"/>
                <a:tab algn="l" pos="10953720"/>
              </a:tabLst>
            </a:pPr>
            <a:endParaRPr b="0" lang="en-US" sz="5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6543720" y="2987640"/>
            <a:ext cx="5622480" cy="4029120"/>
          </a:xfrm>
          <a:prstGeom prst="rect">
            <a:avLst/>
          </a:prstGeom>
          <a:noFill/>
          <a:ln w="0">
            <a:noFill/>
          </a:ln>
        </p:spPr>
        <p:txBody>
          <a:bodyPr lIns="146160" rIns="146160" tIns="73080" bIns="73080" anchor="t">
            <a:normAutofit/>
          </a:bodyPr>
          <a:p>
            <a:pPr indent="0">
              <a:spcBef>
                <a:spcPts val="1276"/>
              </a:spcBef>
              <a:buNone/>
              <a:tabLst>
                <a:tab algn="l" pos="730080"/>
                <a:tab algn="l" pos="1460520"/>
                <a:tab algn="l" pos="2190600"/>
                <a:tab algn="l" pos="2921040"/>
                <a:tab algn="l" pos="3651120"/>
                <a:tab algn="l" pos="4381560"/>
                <a:tab algn="l" pos="5111640"/>
                <a:tab algn="l" pos="5842080"/>
                <a:tab algn="l" pos="6572160"/>
                <a:tab algn="l" pos="7302600"/>
                <a:tab algn="l" pos="8032680"/>
                <a:tab algn="l" pos="8763120"/>
                <a:tab algn="l" pos="9493200"/>
                <a:tab algn="l" pos="10223640"/>
                <a:tab algn="l" pos="10953720"/>
              </a:tabLst>
            </a:pPr>
            <a:endParaRPr b="0" lang="en-US" sz="5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639720" y="7399800"/>
            <a:ext cx="5622480" cy="4029120"/>
          </a:xfrm>
          <a:prstGeom prst="rect">
            <a:avLst/>
          </a:prstGeom>
          <a:noFill/>
          <a:ln w="0">
            <a:noFill/>
          </a:ln>
        </p:spPr>
        <p:txBody>
          <a:bodyPr lIns="146160" rIns="146160" tIns="73080" bIns="73080" anchor="t">
            <a:normAutofit/>
          </a:bodyPr>
          <a:p>
            <a:pPr indent="0">
              <a:spcBef>
                <a:spcPts val="1276"/>
              </a:spcBef>
              <a:buNone/>
              <a:tabLst>
                <a:tab algn="l" pos="730080"/>
                <a:tab algn="l" pos="1460520"/>
                <a:tab algn="l" pos="2190600"/>
                <a:tab algn="l" pos="2921040"/>
                <a:tab algn="l" pos="3651120"/>
                <a:tab algn="l" pos="4381560"/>
                <a:tab algn="l" pos="5111640"/>
                <a:tab algn="l" pos="5842080"/>
                <a:tab algn="l" pos="6572160"/>
                <a:tab algn="l" pos="7302600"/>
                <a:tab algn="l" pos="8032680"/>
                <a:tab algn="l" pos="8763120"/>
                <a:tab algn="l" pos="9493200"/>
                <a:tab algn="l" pos="10223640"/>
                <a:tab algn="l" pos="10953720"/>
              </a:tabLst>
            </a:pPr>
            <a:endParaRPr b="0" lang="en-US" sz="5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6543720" y="7399800"/>
            <a:ext cx="5622480" cy="4029120"/>
          </a:xfrm>
          <a:prstGeom prst="rect">
            <a:avLst/>
          </a:prstGeom>
          <a:noFill/>
          <a:ln w="0">
            <a:noFill/>
          </a:ln>
        </p:spPr>
        <p:txBody>
          <a:bodyPr lIns="146160" rIns="146160" tIns="73080" bIns="73080" anchor="t">
            <a:normAutofit/>
          </a:bodyPr>
          <a:p>
            <a:pPr indent="0">
              <a:spcBef>
                <a:spcPts val="1276"/>
              </a:spcBef>
              <a:buNone/>
              <a:tabLst>
                <a:tab algn="l" pos="730080"/>
                <a:tab algn="l" pos="1460520"/>
                <a:tab algn="l" pos="2190600"/>
                <a:tab algn="l" pos="2921040"/>
                <a:tab algn="l" pos="3651120"/>
                <a:tab algn="l" pos="4381560"/>
                <a:tab algn="l" pos="5111640"/>
                <a:tab algn="l" pos="5842080"/>
                <a:tab algn="l" pos="6572160"/>
                <a:tab algn="l" pos="7302600"/>
                <a:tab algn="l" pos="8032680"/>
                <a:tab algn="l" pos="8763120"/>
                <a:tab algn="l" pos="9493200"/>
                <a:tab algn="l" pos="10223640"/>
                <a:tab algn="l" pos="10953720"/>
              </a:tabLst>
            </a:pPr>
            <a:endParaRPr b="0" lang="en-US" sz="5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01CCAD3-8898-46A1-BCE6-FF2D5CBC988C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639720" y="512280"/>
            <a:ext cx="11522160" cy="2133720"/>
          </a:xfrm>
          <a:prstGeom prst="rect">
            <a:avLst/>
          </a:prstGeom>
          <a:noFill/>
          <a:ln w="0">
            <a:noFill/>
          </a:ln>
        </p:spPr>
        <p:txBody>
          <a:bodyPr lIns="146160" rIns="146160" tIns="73080" bIns="73080" anchor="ctr">
            <a:noAutofit/>
          </a:bodyPr>
          <a:p>
            <a:pPr indent="0" algn="ctr">
              <a:buNone/>
              <a:tabLst>
                <a:tab algn="l" pos="0"/>
                <a:tab algn="l" pos="730080"/>
                <a:tab algn="l" pos="1460520"/>
                <a:tab algn="l" pos="2190600"/>
                <a:tab algn="l" pos="2921040"/>
                <a:tab algn="l" pos="3651120"/>
                <a:tab algn="l" pos="4381560"/>
                <a:tab algn="l" pos="5111640"/>
                <a:tab algn="l" pos="5842080"/>
                <a:tab algn="l" pos="6572160"/>
                <a:tab algn="l" pos="7302600"/>
                <a:tab algn="l" pos="8032680"/>
                <a:tab algn="l" pos="8763120"/>
                <a:tab algn="l" pos="9493200"/>
                <a:tab algn="l" pos="10223640"/>
                <a:tab algn="l" pos="10953720"/>
              </a:tabLst>
            </a:pPr>
            <a:endParaRPr b="0" lang="en-US" sz="7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639720" y="2987640"/>
            <a:ext cx="3709800" cy="4029120"/>
          </a:xfrm>
          <a:prstGeom prst="rect">
            <a:avLst/>
          </a:prstGeom>
          <a:noFill/>
          <a:ln w="0">
            <a:noFill/>
          </a:ln>
        </p:spPr>
        <p:txBody>
          <a:bodyPr lIns="146160" rIns="146160" tIns="73080" bIns="73080" anchor="t">
            <a:normAutofit/>
          </a:bodyPr>
          <a:p>
            <a:pPr indent="0">
              <a:spcBef>
                <a:spcPts val="1276"/>
              </a:spcBef>
              <a:buNone/>
              <a:tabLst>
                <a:tab algn="l" pos="730080"/>
                <a:tab algn="l" pos="1460520"/>
                <a:tab algn="l" pos="2190600"/>
                <a:tab algn="l" pos="2921040"/>
                <a:tab algn="l" pos="3651120"/>
                <a:tab algn="l" pos="4381560"/>
                <a:tab algn="l" pos="5111640"/>
                <a:tab algn="l" pos="5842080"/>
                <a:tab algn="l" pos="6572160"/>
                <a:tab algn="l" pos="7302600"/>
                <a:tab algn="l" pos="8032680"/>
                <a:tab algn="l" pos="8763120"/>
                <a:tab algn="l" pos="9493200"/>
                <a:tab algn="l" pos="10223640"/>
                <a:tab algn="l" pos="10953720"/>
              </a:tabLst>
            </a:pPr>
            <a:endParaRPr b="0" lang="en-US" sz="5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4535280" y="2987640"/>
            <a:ext cx="3709800" cy="4029120"/>
          </a:xfrm>
          <a:prstGeom prst="rect">
            <a:avLst/>
          </a:prstGeom>
          <a:noFill/>
          <a:ln w="0">
            <a:noFill/>
          </a:ln>
        </p:spPr>
        <p:txBody>
          <a:bodyPr lIns="146160" rIns="146160" tIns="73080" bIns="73080" anchor="t">
            <a:normAutofit/>
          </a:bodyPr>
          <a:p>
            <a:pPr indent="0">
              <a:spcBef>
                <a:spcPts val="1276"/>
              </a:spcBef>
              <a:buNone/>
              <a:tabLst>
                <a:tab algn="l" pos="730080"/>
                <a:tab algn="l" pos="1460520"/>
                <a:tab algn="l" pos="2190600"/>
                <a:tab algn="l" pos="2921040"/>
                <a:tab algn="l" pos="3651120"/>
                <a:tab algn="l" pos="4381560"/>
                <a:tab algn="l" pos="5111640"/>
                <a:tab algn="l" pos="5842080"/>
                <a:tab algn="l" pos="6572160"/>
                <a:tab algn="l" pos="7302600"/>
                <a:tab algn="l" pos="8032680"/>
                <a:tab algn="l" pos="8763120"/>
                <a:tab algn="l" pos="9493200"/>
                <a:tab algn="l" pos="10223640"/>
                <a:tab algn="l" pos="10953720"/>
              </a:tabLst>
            </a:pPr>
            <a:endParaRPr b="0" lang="en-US" sz="5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8431200" y="2987640"/>
            <a:ext cx="3709800" cy="4029120"/>
          </a:xfrm>
          <a:prstGeom prst="rect">
            <a:avLst/>
          </a:prstGeom>
          <a:noFill/>
          <a:ln w="0">
            <a:noFill/>
          </a:ln>
        </p:spPr>
        <p:txBody>
          <a:bodyPr lIns="146160" rIns="146160" tIns="73080" bIns="73080" anchor="t">
            <a:normAutofit/>
          </a:bodyPr>
          <a:p>
            <a:pPr indent="0">
              <a:spcBef>
                <a:spcPts val="1276"/>
              </a:spcBef>
              <a:buNone/>
              <a:tabLst>
                <a:tab algn="l" pos="730080"/>
                <a:tab algn="l" pos="1460520"/>
                <a:tab algn="l" pos="2190600"/>
                <a:tab algn="l" pos="2921040"/>
                <a:tab algn="l" pos="3651120"/>
                <a:tab algn="l" pos="4381560"/>
                <a:tab algn="l" pos="5111640"/>
                <a:tab algn="l" pos="5842080"/>
                <a:tab algn="l" pos="6572160"/>
                <a:tab algn="l" pos="7302600"/>
                <a:tab algn="l" pos="8032680"/>
                <a:tab algn="l" pos="8763120"/>
                <a:tab algn="l" pos="9493200"/>
                <a:tab algn="l" pos="10223640"/>
                <a:tab algn="l" pos="10953720"/>
              </a:tabLst>
            </a:pPr>
            <a:endParaRPr b="0" lang="en-US" sz="5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639720" y="7399800"/>
            <a:ext cx="3709800" cy="4029120"/>
          </a:xfrm>
          <a:prstGeom prst="rect">
            <a:avLst/>
          </a:prstGeom>
          <a:noFill/>
          <a:ln w="0">
            <a:noFill/>
          </a:ln>
        </p:spPr>
        <p:txBody>
          <a:bodyPr lIns="146160" rIns="146160" tIns="73080" bIns="73080" anchor="t">
            <a:normAutofit/>
          </a:bodyPr>
          <a:p>
            <a:pPr indent="0">
              <a:spcBef>
                <a:spcPts val="1276"/>
              </a:spcBef>
              <a:buNone/>
              <a:tabLst>
                <a:tab algn="l" pos="730080"/>
                <a:tab algn="l" pos="1460520"/>
                <a:tab algn="l" pos="2190600"/>
                <a:tab algn="l" pos="2921040"/>
                <a:tab algn="l" pos="3651120"/>
                <a:tab algn="l" pos="4381560"/>
                <a:tab algn="l" pos="5111640"/>
                <a:tab algn="l" pos="5842080"/>
                <a:tab algn="l" pos="6572160"/>
                <a:tab algn="l" pos="7302600"/>
                <a:tab algn="l" pos="8032680"/>
                <a:tab algn="l" pos="8763120"/>
                <a:tab algn="l" pos="9493200"/>
                <a:tab algn="l" pos="10223640"/>
                <a:tab algn="l" pos="10953720"/>
              </a:tabLst>
            </a:pPr>
            <a:endParaRPr b="0" lang="en-US" sz="5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4535280" y="7399800"/>
            <a:ext cx="3709800" cy="4029120"/>
          </a:xfrm>
          <a:prstGeom prst="rect">
            <a:avLst/>
          </a:prstGeom>
          <a:noFill/>
          <a:ln w="0">
            <a:noFill/>
          </a:ln>
        </p:spPr>
        <p:txBody>
          <a:bodyPr lIns="146160" rIns="146160" tIns="73080" bIns="73080" anchor="t">
            <a:normAutofit/>
          </a:bodyPr>
          <a:p>
            <a:pPr indent="0">
              <a:spcBef>
                <a:spcPts val="1276"/>
              </a:spcBef>
              <a:buNone/>
              <a:tabLst>
                <a:tab algn="l" pos="730080"/>
                <a:tab algn="l" pos="1460520"/>
                <a:tab algn="l" pos="2190600"/>
                <a:tab algn="l" pos="2921040"/>
                <a:tab algn="l" pos="3651120"/>
                <a:tab algn="l" pos="4381560"/>
                <a:tab algn="l" pos="5111640"/>
                <a:tab algn="l" pos="5842080"/>
                <a:tab algn="l" pos="6572160"/>
                <a:tab algn="l" pos="7302600"/>
                <a:tab algn="l" pos="8032680"/>
                <a:tab algn="l" pos="8763120"/>
                <a:tab algn="l" pos="9493200"/>
                <a:tab algn="l" pos="10223640"/>
                <a:tab algn="l" pos="10953720"/>
              </a:tabLst>
            </a:pPr>
            <a:endParaRPr b="0" lang="en-US" sz="5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8431200" y="7399800"/>
            <a:ext cx="3709800" cy="4029120"/>
          </a:xfrm>
          <a:prstGeom prst="rect">
            <a:avLst/>
          </a:prstGeom>
          <a:noFill/>
          <a:ln w="0">
            <a:noFill/>
          </a:ln>
        </p:spPr>
        <p:txBody>
          <a:bodyPr lIns="146160" rIns="146160" tIns="73080" bIns="73080" anchor="t">
            <a:normAutofit/>
          </a:bodyPr>
          <a:p>
            <a:pPr indent="0">
              <a:spcBef>
                <a:spcPts val="1276"/>
              </a:spcBef>
              <a:buNone/>
              <a:tabLst>
                <a:tab algn="l" pos="730080"/>
                <a:tab algn="l" pos="1460520"/>
                <a:tab algn="l" pos="2190600"/>
                <a:tab algn="l" pos="2921040"/>
                <a:tab algn="l" pos="3651120"/>
                <a:tab algn="l" pos="4381560"/>
                <a:tab algn="l" pos="5111640"/>
                <a:tab algn="l" pos="5842080"/>
                <a:tab algn="l" pos="6572160"/>
                <a:tab algn="l" pos="7302600"/>
                <a:tab algn="l" pos="8032680"/>
                <a:tab algn="l" pos="8763120"/>
                <a:tab algn="l" pos="9493200"/>
                <a:tab algn="l" pos="10223640"/>
                <a:tab algn="l" pos="10953720"/>
              </a:tabLst>
            </a:pPr>
            <a:endParaRPr b="0" lang="en-US" sz="5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67189FF-87D6-4D91-B28D-1B643A2D7A46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639720" y="512280"/>
            <a:ext cx="11522160" cy="2133720"/>
          </a:xfrm>
          <a:prstGeom prst="rect">
            <a:avLst/>
          </a:prstGeom>
          <a:noFill/>
          <a:ln w="0">
            <a:noFill/>
          </a:ln>
        </p:spPr>
        <p:txBody>
          <a:bodyPr lIns="146160" rIns="146160" tIns="73080" bIns="73080" anchor="ctr">
            <a:noAutofit/>
          </a:bodyPr>
          <a:p>
            <a:pPr indent="0" algn="ctr">
              <a:buNone/>
              <a:tabLst>
                <a:tab algn="l" pos="0"/>
                <a:tab algn="l" pos="730080"/>
                <a:tab algn="l" pos="1460520"/>
                <a:tab algn="l" pos="2190600"/>
                <a:tab algn="l" pos="2921040"/>
                <a:tab algn="l" pos="3651120"/>
                <a:tab algn="l" pos="4381560"/>
                <a:tab algn="l" pos="5111640"/>
                <a:tab algn="l" pos="5842080"/>
                <a:tab algn="l" pos="6572160"/>
                <a:tab algn="l" pos="7302600"/>
                <a:tab algn="l" pos="8032680"/>
                <a:tab algn="l" pos="8763120"/>
                <a:tab algn="l" pos="9493200"/>
                <a:tab algn="l" pos="10223640"/>
                <a:tab algn="l" pos="10953720"/>
              </a:tabLst>
            </a:pPr>
            <a:endParaRPr b="0" lang="en-US" sz="7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639720" y="2987640"/>
            <a:ext cx="11522160" cy="84470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1276"/>
              </a:spcBef>
              <a:buNone/>
              <a:tabLst>
                <a:tab algn="l" pos="0"/>
                <a:tab algn="l" pos="730080"/>
                <a:tab algn="l" pos="1460520"/>
                <a:tab algn="l" pos="2190600"/>
                <a:tab algn="l" pos="2921040"/>
                <a:tab algn="l" pos="3651120"/>
                <a:tab algn="l" pos="4381560"/>
                <a:tab algn="l" pos="5111640"/>
                <a:tab algn="l" pos="5842080"/>
                <a:tab algn="l" pos="6572160"/>
                <a:tab algn="l" pos="7302600"/>
                <a:tab algn="l" pos="8032680"/>
                <a:tab algn="l" pos="8763120"/>
                <a:tab algn="l" pos="9493200"/>
                <a:tab algn="l" pos="10223640"/>
                <a:tab algn="l" pos="10953720"/>
              </a:tabLst>
            </a:pPr>
            <a:endParaRPr b="0" lang="en-US" sz="5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E1A5EEE-4C94-4A3C-A314-CEF6C0AD5554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639720" y="512280"/>
            <a:ext cx="11522160" cy="2133720"/>
          </a:xfrm>
          <a:prstGeom prst="rect">
            <a:avLst/>
          </a:prstGeom>
          <a:noFill/>
          <a:ln w="0">
            <a:noFill/>
          </a:ln>
        </p:spPr>
        <p:txBody>
          <a:bodyPr lIns="146160" rIns="146160" tIns="73080" bIns="73080" anchor="ctr">
            <a:noAutofit/>
          </a:bodyPr>
          <a:p>
            <a:pPr indent="0" algn="ctr">
              <a:buNone/>
              <a:tabLst>
                <a:tab algn="l" pos="0"/>
                <a:tab algn="l" pos="730080"/>
                <a:tab algn="l" pos="1460520"/>
                <a:tab algn="l" pos="2190600"/>
                <a:tab algn="l" pos="2921040"/>
                <a:tab algn="l" pos="3651120"/>
                <a:tab algn="l" pos="4381560"/>
                <a:tab algn="l" pos="5111640"/>
                <a:tab algn="l" pos="5842080"/>
                <a:tab algn="l" pos="6572160"/>
                <a:tab algn="l" pos="7302600"/>
                <a:tab algn="l" pos="8032680"/>
                <a:tab algn="l" pos="8763120"/>
                <a:tab algn="l" pos="9493200"/>
                <a:tab algn="l" pos="10223640"/>
                <a:tab algn="l" pos="10953720"/>
              </a:tabLst>
            </a:pPr>
            <a:endParaRPr b="0" lang="en-US" sz="7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639720" y="2987640"/>
            <a:ext cx="11522160" cy="8447040"/>
          </a:xfrm>
          <a:prstGeom prst="rect">
            <a:avLst/>
          </a:prstGeom>
          <a:noFill/>
          <a:ln w="0">
            <a:noFill/>
          </a:ln>
        </p:spPr>
        <p:txBody>
          <a:bodyPr lIns="146160" rIns="146160" tIns="73080" bIns="73080" anchor="t">
            <a:normAutofit/>
          </a:bodyPr>
          <a:p>
            <a:pPr indent="0">
              <a:spcBef>
                <a:spcPts val="1276"/>
              </a:spcBef>
              <a:buNone/>
              <a:tabLst>
                <a:tab algn="l" pos="730080"/>
                <a:tab algn="l" pos="1460520"/>
                <a:tab algn="l" pos="2190600"/>
                <a:tab algn="l" pos="2921040"/>
                <a:tab algn="l" pos="3651120"/>
                <a:tab algn="l" pos="4381560"/>
                <a:tab algn="l" pos="5111640"/>
                <a:tab algn="l" pos="5842080"/>
                <a:tab algn="l" pos="6572160"/>
                <a:tab algn="l" pos="7302600"/>
                <a:tab algn="l" pos="8032680"/>
                <a:tab algn="l" pos="8763120"/>
                <a:tab algn="l" pos="9493200"/>
                <a:tab algn="l" pos="10223640"/>
                <a:tab algn="l" pos="10953720"/>
              </a:tabLst>
            </a:pPr>
            <a:endParaRPr b="0" lang="en-US" sz="5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0B7301C-8277-44CA-81AE-5DB413B9A07D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639720" y="512280"/>
            <a:ext cx="11522160" cy="2133720"/>
          </a:xfrm>
          <a:prstGeom prst="rect">
            <a:avLst/>
          </a:prstGeom>
          <a:noFill/>
          <a:ln w="0">
            <a:noFill/>
          </a:ln>
        </p:spPr>
        <p:txBody>
          <a:bodyPr lIns="146160" rIns="146160" tIns="73080" bIns="73080" anchor="ctr">
            <a:noAutofit/>
          </a:bodyPr>
          <a:p>
            <a:pPr indent="0" algn="ctr">
              <a:buNone/>
              <a:tabLst>
                <a:tab algn="l" pos="0"/>
                <a:tab algn="l" pos="730080"/>
                <a:tab algn="l" pos="1460520"/>
                <a:tab algn="l" pos="2190600"/>
                <a:tab algn="l" pos="2921040"/>
                <a:tab algn="l" pos="3651120"/>
                <a:tab algn="l" pos="4381560"/>
                <a:tab algn="l" pos="5111640"/>
                <a:tab algn="l" pos="5842080"/>
                <a:tab algn="l" pos="6572160"/>
                <a:tab algn="l" pos="7302600"/>
                <a:tab algn="l" pos="8032680"/>
                <a:tab algn="l" pos="8763120"/>
                <a:tab algn="l" pos="9493200"/>
                <a:tab algn="l" pos="10223640"/>
                <a:tab algn="l" pos="10953720"/>
              </a:tabLst>
            </a:pPr>
            <a:endParaRPr b="0" lang="en-US" sz="7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639720" y="2987640"/>
            <a:ext cx="5622480" cy="8447040"/>
          </a:xfrm>
          <a:prstGeom prst="rect">
            <a:avLst/>
          </a:prstGeom>
          <a:noFill/>
          <a:ln w="0">
            <a:noFill/>
          </a:ln>
        </p:spPr>
        <p:txBody>
          <a:bodyPr lIns="146160" rIns="146160" tIns="73080" bIns="73080" anchor="t">
            <a:normAutofit/>
          </a:bodyPr>
          <a:p>
            <a:pPr indent="0">
              <a:spcBef>
                <a:spcPts val="1276"/>
              </a:spcBef>
              <a:buNone/>
              <a:tabLst>
                <a:tab algn="l" pos="730080"/>
                <a:tab algn="l" pos="1460520"/>
                <a:tab algn="l" pos="2190600"/>
                <a:tab algn="l" pos="2921040"/>
                <a:tab algn="l" pos="3651120"/>
                <a:tab algn="l" pos="4381560"/>
                <a:tab algn="l" pos="5111640"/>
                <a:tab algn="l" pos="5842080"/>
                <a:tab algn="l" pos="6572160"/>
                <a:tab algn="l" pos="7302600"/>
                <a:tab algn="l" pos="8032680"/>
                <a:tab algn="l" pos="8763120"/>
                <a:tab algn="l" pos="9493200"/>
                <a:tab algn="l" pos="10223640"/>
                <a:tab algn="l" pos="10953720"/>
              </a:tabLst>
            </a:pPr>
            <a:endParaRPr b="0" lang="en-US" sz="5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6543720" y="2987640"/>
            <a:ext cx="5622480" cy="8447040"/>
          </a:xfrm>
          <a:prstGeom prst="rect">
            <a:avLst/>
          </a:prstGeom>
          <a:noFill/>
          <a:ln w="0">
            <a:noFill/>
          </a:ln>
        </p:spPr>
        <p:txBody>
          <a:bodyPr lIns="146160" rIns="146160" tIns="73080" bIns="73080" anchor="t">
            <a:normAutofit/>
          </a:bodyPr>
          <a:p>
            <a:pPr indent="0">
              <a:spcBef>
                <a:spcPts val="1276"/>
              </a:spcBef>
              <a:buNone/>
              <a:tabLst>
                <a:tab algn="l" pos="730080"/>
                <a:tab algn="l" pos="1460520"/>
                <a:tab algn="l" pos="2190600"/>
                <a:tab algn="l" pos="2921040"/>
                <a:tab algn="l" pos="3651120"/>
                <a:tab algn="l" pos="4381560"/>
                <a:tab algn="l" pos="5111640"/>
                <a:tab algn="l" pos="5842080"/>
                <a:tab algn="l" pos="6572160"/>
                <a:tab algn="l" pos="7302600"/>
                <a:tab algn="l" pos="8032680"/>
                <a:tab algn="l" pos="8763120"/>
                <a:tab algn="l" pos="9493200"/>
                <a:tab algn="l" pos="10223640"/>
                <a:tab algn="l" pos="10953720"/>
              </a:tabLst>
            </a:pPr>
            <a:endParaRPr b="0" lang="en-US" sz="5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AB0703A-11C6-400C-AC20-DD06116E0C95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639720" y="512280"/>
            <a:ext cx="11522160" cy="2133720"/>
          </a:xfrm>
          <a:prstGeom prst="rect">
            <a:avLst/>
          </a:prstGeom>
          <a:noFill/>
          <a:ln w="0">
            <a:noFill/>
          </a:ln>
        </p:spPr>
        <p:txBody>
          <a:bodyPr lIns="146160" rIns="146160" tIns="73080" bIns="73080" anchor="ctr">
            <a:noAutofit/>
          </a:bodyPr>
          <a:p>
            <a:pPr indent="0" algn="ctr">
              <a:buNone/>
              <a:tabLst>
                <a:tab algn="l" pos="0"/>
                <a:tab algn="l" pos="730080"/>
                <a:tab algn="l" pos="1460520"/>
                <a:tab algn="l" pos="2190600"/>
                <a:tab algn="l" pos="2921040"/>
                <a:tab algn="l" pos="3651120"/>
                <a:tab algn="l" pos="4381560"/>
                <a:tab algn="l" pos="5111640"/>
                <a:tab algn="l" pos="5842080"/>
                <a:tab algn="l" pos="6572160"/>
                <a:tab algn="l" pos="7302600"/>
                <a:tab algn="l" pos="8032680"/>
                <a:tab algn="l" pos="8763120"/>
                <a:tab algn="l" pos="9493200"/>
                <a:tab algn="l" pos="10223640"/>
                <a:tab algn="l" pos="10953720"/>
              </a:tabLst>
            </a:pPr>
            <a:endParaRPr b="0" lang="en-US" sz="7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6F56C22-E7BE-48CD-85DC-998A0C1E562F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639720" y="512280"/>
            <a:ext cx="11522160" cy="98920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1276"/>
              </a:spcBef>
              <a:tabLst>
                <a:tab algn="l" pos="0"/>
                <a:tab algn="l" pos="730080"/>
                <a:tab algn="l" pos="1460520"/>
                <a:tab algn="l" pos="2190600"/>
                <a:tab algn="l" pos="2921040"/>
                <a:tab algn="l" pos="3651120"/>
                <a:tab algn="l" pos="4381560"/>
                <a:tab algn="l" pos="5111640"/>
                <a:tab algn="l" pos="5842080"/>
                <a:tab algn="l" pos="6572160"/>
                <a:tab algn="l" pos="7302600"/>
                <a:tab algn="l" pos="8032680"/>
                <a:tab algn="l" pos="8763120"/>
                <a:tab algn="l" pos="9493200"/>
                <a:tab algn="l" pos="10223640"/>
                <a:tab algn="l" pos="10953720"/>
              </a:tabLst>
            </a:pPr>
            <a:endParaRPr b="0" lang="en-US" sz="5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31DE07D-4443-4A00-806B-D21944CD8E60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639720" y="512280"/>
            <a:ext cx="11522160" cy="2133720"/>
          </a:xfrm>
          <a:prstGeom prst="rect">
            <a:avLst/>
          </a:prstGeom>
          <a:noFill/>
          <a:ln w="0">
            <a:noFill/>
          </a:ln>
        </p:spPr>
        <p:txBody>
          <a:bodyPr lIns="146160" rIns="146160" tIns="73080" bIns="73080" anchor="ctr">
            <a:noAutofit/>
          </a:bodyPr>
          <a:p>
            <a:pPr indent="0" algn="ctr">
              <a:buNone/>
              <a:tabLst>
                <a:tab algn="l" pos="0"/>
                <a:tab algn="l" pos="730080"/>
                <a:tab algn="l" pos="1460520"/>
                <a:tab algn="l" pos="2190600"/>
                <a:tab algn="l" pos="2921040"/>
                <a:tab algn="l" pos="3651120"/>
                <a:tab algn="l" pos="4381560"/>
                <a:tab algn="l" pos="5111640"/>
                <a:tab algn="l" pos="5842080"/>
                <a:tab algn="l" pos="6572160"/>
                <a:tab algn="l" pos="7302600"/>
                <a:tab algn="l" pos="8032680"/>
                <a:tab algn="l" pos="8763120"/>
                <a:tab algn="l" pos="9493200"/>
                <a:tab algn="l" pos="10223640"/>
                <a:tab algn="l" pos="10953720"/>
              </a:tabLst>
            </a:pPr>
            <a:endParaRPr b="0" lang="en-US" sz="7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639720" y="2987640"/>
            <a:ext cx="5622480" cy="4029120"/>
          </a:xfrm>
          <a:prstGeom prst="rect">
            <a:avLst/>
          </a:prstGeom>
          <a:noFill/>
          <a:ln w="0">
            <a:noFill/>
          </a:ln>
        </p:spPr>
        <p:txBody>
          <a:bodyPr lIns="146160" rIns="146160" tIns="73080" bIns="73080" anchor="t">
            <a:normAutofit/>
          </a:bodyPr>
          <a:p>
            <a:pPr indent="0">
              <a:spcBef>
                <a:spcPts val="1276"/>
              </a:spcBef>
              <a:buNone/>
              <a:tabLst>
                <a:tab algn="l" pos="730080"/>
                <a:tab algn="l" pos="1460520"/>
                <a:tab algn="l" pos="2190600"/>
                <a:tab algn="l" pos="2921040"/>
                <a:tab algn="l" pos="3651120"/>
                <a:tab algn="l" pos="4381560"/>
                <a:tab algn="l" pos="5111640"/>
                <a:tab algn="l" pos="5842080"/>
                <a:tab algn="l" pos="6572160"/>
                <a:tab algn="l" pos="7302600"/>
                <a:tab algn="l" pos="8032680"/>
                <a:tab algn="l" pos="8763120"/>
                <a:tab algn="l" pos="9493200"/>
                <a:tab algn="l" pos="10223640"/>
                <a:tab algn="l" pos="10953720"/>
              </a:tabLst>
            </a:pPr>
            <a:endParaRPr b="0" lang="en-US" sz="5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6543720" y="2987640"/>
            <a:ext cx="5622480" cy="8447040"/>
          </a:xfrm>
          <a:prstGeom prst="rect">
            <a:avLst/>
          </a:prstGeom>
          <a:noFill/>
          <a:ln w="0">
            <a:noFill/>
          </a:ln>
        </p:spPr>
        <p:txBody>
          <a:bodyPr lIns="146160" rIns="146160" tIns="73080" bIns="73080" anchor="t">
            <a:normAutofit/>
          </a:bodyPr>
          <a:p>
            <a:pPr indent="0">
              <a:spcBef>
                <a:spcPts val="1276"/>
              </a:spcBef>
              <a:buNone/>
              <a:tabLst>
                <a:tab algn="l" pos="730080"/>
                <a:tab algn="l" pos="1460520"/>
                <a:tab algn="l" pos="2190600"/>
                <a:tab algn="l" pos="2921040"/>
                <a:tab algn="l" pos="3651120"/>
                <a:tab algn="l" pos="4381560"/>
                <a:tab algn="l" pos="5111640"/>
                <a:tab algn="l" pos="5842080"/>
                <a:tab algn="l" pos="6572160"/>
                <a:tab algn="l" pos="7302600"/>
                <a:tab algn="l" pos="8032680"/>
                <a:tab algn="l" pos="8763120"/>
                <a:tab algn="l" pos="9493200"/>
                <a:tab algn="l" pos="10223640"/>
                <a:tab algn="l" pos="10953720"/>
              </a:tabLst>
            </a:pPr>
            <a:endParaRPr b="0" lang="en-US" sz="5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639720" y="7399800"/>
            <a:ext cx="5622480" cy="4029120"/>
          </a:xfrm>
          <a:prstGeom prst="rect">
            <a:avLst/>
          </a:prstGeom>
          <a:noFill/>
          <a:ln w="0">
            <a:noFill/>
          </a:ln>
        </p:spPr>
        <p:txBody>
          <a:bodyPr lIns="146160" rIns="146160" tIns="73080" bIns="73080" anchor="t">
            <a:normAutofit/>
          </a:bodyPr>
          <a:p>
            <a:pPr indent="0">
              <a:spcBef>
                <a:spcPts val="1276"/>
              </a:spcBef>
              <a:buNone/>
              <a:tabLst>
                <a:tab algn="l" pos="730080"/>
                <a:tab algn="l" pos="1460520"/>
                <a:tab algn="l" pos="2190600"/>
                <a:tab algn="l" pos="2921040"/>
                <a:tab algn="l" pos="3651120"/>
                <a:tab algn="l" pos="4381560"/>
                <a:tab algn="l" pos="5111640"/>
                <a:tab algn="l" pos="5842080"/>
                <a:tab algn="l" pos="6572160"/>
                <a:tab algn="l" pos="7302600"/>
                <a:tab algn="l" pos="8032680"/>
                <a:tab algn="l" pos="8763120"/>
                <a:tab algn="l" pos="9493200"/>
                <a:tab algn="l" pos="10223640"/>
                <a:tab algn="l" pos="10953720"/>
              </a:tabLst>
            </a:pPr>
            <a:endParaRPr b="0" lang="en-US" sz="5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A61D2AB-69F0-4B14-A957-E78C6631A1D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639720" y="512280"/>
            <a:ext cx="11522160" cy="2133720"/>
          </a:xfrm>
          <a:prstGeom prst="rect">
            <a:avLst/>
          </a:prstGeom>
          <a:noFill/>
          <a:ln w="0">
            <a:noFill/>
          </a:ln>
        </p:spPr>
        <p:txBody>
          <a:bodyPr lIns="146160" rIns="146160" tIns="73080" bIns="73080" anchor="ctr">
            <a:noAutofit/>
          </a:bodyPr>
          <a:p>
            <a:pPr indent="0" algn="ctr">
              <a:buNone/>
              <a:tabLst>
                <a:tab algn="l" pos="0"/>
                <a:tab algn="l" pos="730080"/>
                <a:tab algn="l" pos="1460520"/>
                <a:tab algn="l" pos="2190600"/>
                <a:tab algn="l" pos="2921040"/>
                <a:tab algn="l" pos="3651120"/>
                <a:tab algn="l" pos="4381560"/>
                <a:tab algn="l" pos="5111640"/>
                <a:tab algn="l" pos="5842080"/>
                <a:tab algn="l" pos="6572160"/>
                <a:tab algn="l" pos="7302600"/>
                <a:tab algn="l" pos="8032680"/>
                <a:tab algn="l" pos="8763120"/>
                <a:tab algn="l" pos="9493200"/>
                <a:tab algn="l" pos="10223640"/>
                <a:tab algn="l" pos="10953720"/>
              </a:tabLst>
            </a:pPr>
            <a:endParaRPr b="0" lang="en-US" sz="7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639720" y="2987640"/>
            <a:ext cx="5622480" cy="8447040"/>
          </a:xfrm>
          <a:prstGeom prst="rect">
            <a:avLst/>
          </a:prstGeom>
          <a:noFill/>
          <a:ln w="0">
            <a:noFill/>
          </a:ln>
        </p:spPr>
        <p:txBody>
          <a:bodyPr lIns="146160" rIns="146160" tIns="73080" bIns="73080" anchor="t">
            <a:normAutofit/>
          </a:bodyPr>
          <a:p>
            <a:pPr indent="0">
              <a:spcBef>
                <a:spcPts val="1276"/>
              </a:spcBef>
              <a:buNone/>
              <a:tabLst>
                <a:tab algn="l" pos="730080"/>
                <a:tab algn="l" pos="1460520"/>
                <a:tab algn="l" pos="2190600"/>
                <a:tab algn="l" pos="2921040"/>
                <a:tab algn="l" pos="3651120"/>
                <a:tab algn="l" pos="4381560"/>
                <a:tab algn="l" pos="5111640"/>
                <a:tab algn="l" pos="5842080"/>
                <a:tab algn="l" pos="6572160"/>
                <a:tab algn="l" pos="7302600"/>
                <a:tab algn="l" pos="8032680"/>
                <a:tab algn="l" pos="8763120"/>
                <a:tab algn="l" pos="9493200"/>
                <a:tab algn="l" pos="10223640"/>
                <a:tab algn="l" pos="10953720"/>
              </a:tabLst>
            </a:pPr>
            <a:endParaRPr b="0" lang="en-US" sz="5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6543720" y="2987640"/>
            <a:ext cx="5622480" cy="4029120"/>
          </a:xfrm>
          <a:prstGeom prst="rect">
            <a:avLst/>
          </a:prstGeom>
          <a:noFill/>
          <a:ln w="0">
            <a:noFill/>
          </a:ln>
        </p:spPr>
        <p:txBody>
          <a:bodyPr lIns="146160" rIns="146160" tIns="73080" bIns="73080" anchor="t">
            <a:normAutofit/>
          </a:bodyPr>
          <a:p>
            <a:pPr indent="0">
              <a:spcBef>
                <a:spcPts val="1276"/>
              </a:spcBef>
              <a:buNone/>
              <a:tabLst>
                <a:tab algn="l" pos="730080"/>
                <a:tab algn="l" pos="1460520"/>
                <a:tab algn="l" pos="2190600"/>
                <a:tab algn="l" pos="2921040"/>
                <a:tab algn="l" pos="3651120"/>
                <a:tab algn="l" pos="4381560"/>
                <a:tab algn="l" pos="5111640"/>
                <a:tab algn="l" pos="5842080"/>
                <a:tab algn="l" pos="6572160"/>
                <a:tab algn="l" pos="7302600"/>
                <a:tab algn="l" pos="8032680"/>
                <a:tab algn="l" pos="8763120"/>
                <a:tab algn="l" pos="9493200"/>
                <a:tab algn="l" pos="10223640"/>
                <a:tab algn="l" pos="10953720"/>
              </a:tabLst>
            </a:pPr>
            <a:endParaRPr b="0" lang="en-US" sz="5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6543720" y="7399800"/>
            <a:ext cx="5622480" cy="4029120"/>
          </a:xfrm>
          <a:prstGeom prst="rect">
            <a:avLst/>
          </a:prstGeom>
          <a:noFill/>
          <a:ln w="0">
            <a:noFill/>
          </a:ln>
        </p:spPr>
        <p:txBody>
          <a:bodyPr lIns="146160" rIns="146160" tIns="73080" bIns="73080" anchor="t">
            <a:normAutofit/>
          </a:bodyPr>
          <a:p>
            <a:pPr indent="0">
              <a:spcBef>
                <a:spcPts val="1276"/>
              </a:spcBef>
              <a:buNone/>
              <a:tabLst>
                <a:tab algn="l" pos="730080"/>
                <a:tab algn="l" pos="1460520"/>
                <a:tab algn="l" pos="2190600"/>
                <a:tab algn="l" pos="2921040"/>
                <a:tab algn="l" pos="3651120"/>
                <a:tab algn="l" pos="4381560"/>
                <a:tab algn="l" pos="5111640"/>
                <a:tab algn="l" pos="5842080"/>
                <a:tab algn="l" pos="6572160"/>
                <a:tab algn="l" pos="7302600"/>
                <a:tab algn="l" pos="8032680"/>
                <a:tab algn="l" pos="8763120"/>
                <a:tab algn="l" pos="9493200"/>
                <a:tab algn="l" pos="10223640"/>
                <a:tab algn="l" pos="10953720"/>
              </a:tabLst>
            </a:pPr>
            <a:endParaRPr b="0" lang="en-US" sz="5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6F1E9A4-DA2B-43C9-808B-DA0DB940655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639720" y="512280"/>
            <a:ext cx="11522160" cy="2133720"/>
          </a:xfrm>
          <a:prstGeom prst="rect">
            <a:avLst/>
          </a:prstGeom>
          <a:noFill/>
          <a:ln w="0">
            <a:noFill/>
          </a:ln>
        </p:spPr>
        <p:txBody>
          <a:bodyPr lIns="146160" rIns="146160" tIns="73080" bIns="73080" anchor="ctr">
            <a:noAutofit/>
          </a:bodyPr>
          <a:p>
            <a:pPr indent="0" algn="ctr">
              <a:buNone/>
              <a:tabLst>
                <a:tab algn="l" pos="0"/>
                <a:tab algn="l" pos="730080"/>
                <a:tab algn="l" pos="1460520"/>
                <a:tab algn="l" pos="2190600"/>
                <a:tab algn="l" pos="2921040"/>
                <a:tab algn="l" pos="3651120"/>
                <a:tab algn="l" pos="4381560"/>
                <a:tab algn="l" pos="5111640"/>
                <a:tab algn="l" pos="5842080"/>
                <a:tab algn="l" pos="6572160"/>
                <a:tab algn="l" pos="7302600"/>
                <a:tab algn="l" pos="8032680"/>
                <a:tab algn="l" pos="8763120"/>
                <a:tab algn="l" pos="9493200"/>
                <a:tab algn="l" pos="10223640"/>
                <a:tab algn="l" pos="10953720"/>
              </a:tabLst>
            </a:pPr>
            <a:endParaRPr b="0" lang="en-US" sz="7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639720" y="2987640"/>
            <a:ext cx="5622480" cy="4029120"/>
          </a:xfrm>
          <a:prstGeom prst="rect">
            <a:avLst/>
          </a:prstGeom>
          <a:noFill/>
          <a:ln w="0">
            <a:noFill/>
          </a:ln>
        </p:spPr>
        <p:txBody>
          <a:bodyPr lIns="146160" rIns="146160" tIns="73080" bIns="73080" anchor="t">
            <a:normAutofit/>
          </a:bodyPr>
          <a:p>
            <a:pPr indent="0">
              <a:spcBef>
                <a:spcPts val="1276"/>
              </a:spcBef>
              <a:buNone/>
              <a:tabLst>
                <a:tab algn="l" pos="730080"/>
                <a:tab algn="l" pos="1460520"/>
                <a:tab algn="l" pos="2190600"/>
                <a:tab algn="l" pos="2921040"/>
                <a:tab algn="l" pos="3651120"/>
                <a:tab algn="l" pos="4381560"/>
                <a:tab algn="l" pos="5111640"/>
                <a:tab algn="l" pos="5842080"/>
                <a:tab algn="l" pos="6572160"/>
                <a:tab algn="l" pos="7302600"/>
                <a:tab algn="l" pos="8032680"/>
                <a:tab algn="l" pos="8763120"/>
                <a:tab algn="l" pos="9493200"/>
                <a:tab algn="l" pos="10223640"/>
                <a:tab algn="l" pos="10953720"/>
              </a:tabLst>
            </a:pPr>
            <a:endParaRPr b="0" lang="en-US" sz="5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6543720" y="2987640"/>
            <a:ext cx="5622480" cy="4029120"/>
          </a:xfrm>
          <a:prstGeom prst="rect">
            <a:avLst/>
          </a:prstGeom>
          <a:noFill/>
          <a:ln w="0">
            <a:noFill/>
          </a:ln>
        </p:spPr>
        <p:txBody>
          <a:bodyPr lIns="146160" rIns="146160" tIns="73080" bIns="73080" anchor="t">
            <a:normAutofit/>
          </a:bodyPr>
          <a:p>
            <a:pPr indent="0">
              <a:spcBef>
                <a:spcPts val="1276"/>
              </a:spcBef>
              <a:buNone/>
              <a:tabLst>
                <a:tab algn="l" pos="730080"/>
                <a:tab algn="l" pos="1460520"/>
                <a:tab algn="l" pos="2190600"/>
                <a:tab algn="l" pos="2921040"/>
                <a:tab algn="l" pos="3651120"/>
                <a:tab algn="l" pos="4381560"/>
                <a:tab algn="l" pos="5111640"/>
                <a:tab algn="l" pos="5842080"/>
                <a:tab algn="l" pos="6572160"/>
                <a:tab algn="l" pos="7302600"/>
                <a:tab algn="l" pos="8032680"/>
                <a:tab algn="l" pos="8763120"/>
                <a:tab algn="l" pos="9493200"/>
                <a:tab algn="l" pos="10223640"/>
                <a:tab algn="l" pos="10953720"/>
              </a:tabLst>
            </a:pPr>
            <a:endParaRPr b="0" lang="en-US" sz="5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639720" y="7399800"/>
            <a:ext cx="11522160" cy="4029120"/>
          </a:xfrm>
          <a:prstGeom prst="rect">
            <a:avLst/>
          </a:prstGeom>
          <a:noFill/>
          <a:ln w="0">
            <a:noFill/>
          </a:ln>
        </p:spPr>
        <p:txBody>
          <a:bodyPr lIns="146160" rIns="146160" tIns="73080" bIns="73080" anchor="t">
            <a:normAutofit/>
          </a:bodyPr>
          <a:p>
            <a:pPr indent="0">
              <a:spcBef>
                <a:spcPts val="1276"/>
              </a:spcBef>
              <a:buNone/>
              <a:tabLst>
                <a:tab algn="l" pos="730080"/>
                <a:tab algn="l" pos="1460520"/>
                <a:tab algn="l" pos="2190600"/>
                <a:tab algn="l" pos="2921040"/>
                <a:tab algn="l" pos="3651120"/>
                <a:tab algn="l" pos="4381560"/>
                <a:tab algn="l" pos="5111640"/>
                <a:tab algn="l" pos="5842080"/>
                <a:tab algn="l" pos="6572160"/>
                <a:tab algn="l" pos="7302600"/>
                <a:tab algn="l" pos="8032680"/>
                <a:tab algn="l" pos="8763120"/>
                <a:tab algn="l" pos="9493200"/>
                <a:tab algn="l" pos="10223640"/>
                <a:tab algn="l" pos="10953720"/>
              </a:tabLst>
            </a:pPr>
            <a:endParaRPr b="0" lang="en-US" sz="5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231D9AE-8495-46AB-91BE-F73E565FBAA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639720" y="512280"/>
            <a:ext cx="11522160" cy="2133720"/>
          </a:xfrm>
          <a:prstGeom prst="rect">
            <a:avLst/>
          </a:prstGeom>
          <a:noFill/>
          <a:ln w="0">
            <a:noFill/>
          </a:ln>
        </p:spPr>
        <p:txBody>
          <a:bodyPr lIns="146160" rIns="146160" tIns="73080" bIns="73080" anchor="ctr">
            <a:noAutofit/>
          </a:bodyPr>
          <a:p>
            <a:pPr indent="0" algn="ctr">
              <a:buNone/>
              <a:tabLst>
                <a:tab algn="l" pos="0"/>
                <a:tab algn="l" pos="730080"/>
                <a:tab algn="l" pos="1460520"/>
                <a:tab algn="l" pos="2190600"/>
                <a:tab algn="l" pos="2921040"/>
                <a:tab algn="l" pos="3651120"/>
                <a:tab algn="l" pos="4381560"/>
                <a:tab algn="l" pos="5111640"/>
                <a:tab algn="l" pos="5842080"/>
                <a:tab algn="l" pos="6572160"/>
                <a:tab algn="l" pos="7302600"/>
                <a:tab algn="l" pos="8032680"/>
                <a:tab algn="l" pos="8763120"/>
                <a:tab algn="l" pos="9493200"/>
                <a:tab algn="l" pos="10223640"/>
                <a:tab algn="l" pos="10953720"/>
              </a:tabLst>
            </a:pPr>
            <a:r>
              <a:rPr b="0" lang="en-US" sz="70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7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639720" y="2987640"/>
            <a:ext cx="11522160" cy="8447040"/>
          </a:xfrm>
          <a:prstGeom prst="rect">
            <a:avLst/>
          </a:prstGeom>
          <a:noFill/>
          <a:ln w="0">
            <a:noFill/>
          </a:ln>
        </p:spPr>
        <p:txBody>
          <a:bodyPr lIns="146160" rIns="146160" tIns="73080" bIns="73080" anchor="t">
            <a:normAutofit/>
          </a:bodyPr>
          <a:p>
            <a:pPr marL="547560" indent="-547560">
              <a:spcBef>
                <a:spcPts val="1276"/>
              </a:spcBef>
              <a:buClr>
                <a:srgbClr val="000000"/>
              </a:buClr>
              <a:buFont typeface="Arial"/>
              <a:buChar char="•"/>
              <a:tabLst>
                <a:tab algn="l" pos="730080"/>
                <a:tab algn="l" pos="1460520"/>
                <a:tab algn="l" pos="2190600"/>
                <a:tab algn="l" pos="2921040"/>
                <a:tab algn="l" pos="3651120"/>
                <a:tab algn="l" pos="4381560"/>
                <a:tab algn="l" pos="5111640"/>
                <a:tab algn="l" pos="5842080"/>
                <a:tab algn="l" pos="6572160"/>
                <a:tab algn="l" pos="7302600"/>
                <a:tab algn="l" pos="8032680"/>
                <a:tab algn="l" pos="8763120"/>
                <a:tab algn="l" pos="9493200"/>
                <a:tab algn="l" pos="10223640"/>
                <a:tab algn="l" pos="10953720"/>
              </a:tabLst>
            </a:pPr>
            <a:r>
              <a:rPr b="0" lang="en-US" sz="51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5100" spc="-1" strike="noStrike">
              <a:solidFill>
                <a:srgbClr val="000000"/>
              </a:solidFill>
              <a:latin typeface="Calibri"/>
            </a:endParaRPr>
          </a:p>
          <a:p>
            <a:pPr lvl="1" marL="1187280" indent="-457200">
              <a:spcBef>
                <a:spcPts val="1276"/>
              </a:spcBef>
              <a:buClr>
                <a:srgbClr val="000000"/>
              </a:buClr>
              <a:buFont typeface="Arial"/>
              <a:buChar char="–"/>
              <a:tabLst>
                <a:tab algn="l" pos="730080"/>
                <a:tab algn="l" pos="1460520"/>
                <a:tab algn="l" pos="2190600"/>
                <a:tab algn="l" pos="2921040"/>
                <a:tab algn="l" pos="3651120"/>
                <a:tab algn="l" pos="4381560"/>
                <a:tab algn="l" pos="5111640"/>
                <a:tab algn="l" pos="5842080"/>
                <a:tab algn="l" pos="6572160"/>
                <a:tab algn="l" pos="7302600"/>
                <a:tab algn="l" pos="8032680"/>
                <a:tab algn="l" pos="8763120"/>
                <a:tab algn="l" pos="9493200"/>
                <a:tab algn="l" pos="10223640"/>
                <a:tab algn="l" pos="10953720"/>
              </a:tabLst>
            </a:pPr>
            <a:r>
              <a:rPr b="0" lang="en-US" sz="51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5100" spc="-1" strike="noStrike">
              <a:solidFill>
                <a:srgbClr val="000000"/>
              </a:solidFill>
              <a:latin typeface="Calibri"/>
            </a:endParaRPr>
          </a:p>
          <a:p>
            <a:pPr lvl="2" marL="1828800" indent="-365040">
              <a:spcBef>
                <a:spcPts val="1276"/>
              </a:spcBef>
              <a:buClr>
                <a:srgbClr val="000000"/>
              </a:buClr>
              <a:buFont typeface="Arial"/>
              <a:buChar char="•"/>
              <a:tabLst>
                <a:tab algn="l" pos="730080"/>
                <a:tab algn="l" pos="1460520"/>
                <a:tab algn="l" pos="2190600"/>
                <a:tab algn="l" pos="2921040"/>
                <a:tab algn="l" pos="3651120"/>
                <a:tab algn="l" pos="4381560"/>
                <a:tab algn="l" pos="5111640"/>
                <a:tab algn="l" pos="5842080"/>
                <a:tab algn="l" pos="6572160"/>
                <a:tab algn="l" pos="7302600"/>
                <a:tab algn="l" pos="8032680"/>
                <a:tab algn="l" pos="8763120"/>
                <a:tab algn="l" pos="9493200"/>
                <a:tab algn="l" pos="10223640"/>
                <a:tab algn="l" pos="10953720"/>
              </a:tabLst>
            </a:pPr>
            <a:r>
              <a:rPr b="0" lang="en-US" sz="51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5100" spc="-1" strike="noStrike">
              <a:solidFill>
                <a:srgbClr val="000000"/>
              </a:solidFill>
              <a:latin typeface="Calibri"/>
            </a:endParaRPr>
          </a:p>
          <a:p>
            <a:pPr lvl="3" marL="2558880" indent="-365040">
              <a:spcBef>
                <a:spcPts val="1276"/>
              </a:spcBef>
              <a:buClr>
                <a:srgbClr val="000000"/>
              </a:buClr>
              <a:buFont typeface="Arial"/>
              <a:buChar char="–"/>
              <a:tabLst>
                <a:tab algn="l" pos="730080"/>
                <a:tab algn="l" pos="1460520"/>
                <a:tab algn="l" pos="2190600"/>
                <a:tab algn="l" pos="2921040"/>
                <a:tab algn="l" pos="3651120"/>
                <a:tab algn="l" pos="4381560"/>
                <a:tab algn="l" pos="5111640"/>
                <a:tab algn="l" pos="5842080"/>
                <a:tab algn="l" pos="6572160"/>
                <a:tab algn="l" pos="7302600"/>
                <a:tab algn="l" pos="8032680"/>
                <a:tab algn="l" pos="8763120"/>
                <a:tab algn="l" pos="9493200"/>
                <a:tab algn="l" pos="10223640"/>
                <a:tab algn="l" pos="10953720"/>
              </a:tabLst>
            </a:pPr>
            <a:r>
              <a:rPr b="0" lang="en-US" sz="51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5100" spc="-1" strike="noStrike">
              <a:solidFill>
                <a:srgbClr val="000000"/>
              </a:solidFill>
              <a:latin typeface="Calibri"/>
            </a:endParaRPr>
          </a:p>
          <a:p>
            <a:pPr lvl="4" marL="3290760" indent="-365040">
              <a:spcBef>
                <a:spcPts val="1276"/>
              </a:spcBef>
              <a:buClr>
                <a:srgbClr val="000000"/>
              </a:buClr>
              <a:buFont typeface="Arial"/>
              <a:buChar char="»"/>
              <a:tabLst>
                <a:tab algn="l" pos="730080"/>
                <a:tab algn="l" pos="1460520"/>
                <a:tab algn="l" pos="2190600"/>
                <a:tab algn="l" pos="2921040"/>
                <a:tab algn="l" pos="3651120"/>
                <a:tab algn="l" pos="4381560"/>
                <a:tab algn="l" pos="5111640"/>
                <a:tab algn="l" pos="5842080"/>
                <a:tab algn="l" pos="6572160"/>
                <a:tab algn="l" pos="7302600"/>
                <a:tab algn="l" pos="8032680"/>
                <a:tab algn="l" pos="8763120"/>
                <a:tab algn="l" pos="9493200"/>
                <a:tab algn="l" pos="10223640"/>
                <a:tab algn="l" pos="10953720"/>
              </a:tabLst>
            </a:pPr>
            <a:r>
              <a:rPr b="0" lang="en-US" sz="51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5100" spc="-1" strike="noStrike">
              <a:solidFill>
                <a:srgbClr val="000000"/>
              </a:solidFill>
              <a:latin typeface="Calibri"/>
            </a:endParaRPr>
          </a:p>
          <a:p>
            <a:pPr lvl="5" marL="3290760" indent="-365040">
              <a:spcBef>
                <a:spcPts val="1276"/>
              </a:spcBef>
              <a:buClr>
                <a:srgbClr val="000000"/>
              </a:buClr>
              <a:buFont typeface="Arial"/>
              <a:buChar char="»"/>
              <a:tabLst>
                <a:tab algn="l" pos="730080"/>
                <a:tab algn="l" pos="1460520"/>
                <a:tab algn="l" pos="2190600"/>
                <a:tab algn="l" pos="2921040"/>
                <a:tab algn="l" pos="3651120"/>
                <a:tab algn="l" pos="4381560"/>
                <a:tab algn="l" pos="5111640"/>
                <a:tab algn="l" pos="5842080"/>
                <a:tab algn="l" pos="6572160"/>
                <a:tab algn="l" pos="7302600"/>
                <a:tab algn="l" pos="8032680"/>
                <a:tab algn="l" pos="8763120"/>
                <a:tab algn="l" pos="9493200"/>
                <a:tab algn="l" pos="10223640"/>
                <a:tab algn="l" pos="10953720"/>
              </a:tabLst>
            </a:pPr>
            <a:r>
              <a:rPr b="0" lang="en-US" sz="51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5100" spc="-1" strike="noStrike">
              <a:solidFill>
                <a:srgbClr val="000000"/>
              </a:solidFill>
              <a:latin typeface="Calibri"/>
            </a:endParaRPr>
          </a:p>
          <a:p>
            <a:pPr lvl="6" marL="3290760" indent="-365040">
              <a:spcBef>
                <a:spcPts val="1276"/>
              </a:spcBef>
              <a:buClr>
                <a:srgbClr val="000000"/>
              </a:buClr>
              <a:buFont typeface="Arial"/>
              <a:buChar char="»"/>
              <a:tabLst>
                <a:tab algn="l" pos="730080"/>
                <a:tab algn="l" pos="1460520"/>
                <a:tab algn="l" pos="2190600"/>
                <a:tab algn="l" pos="2921040"/>
                <a:tab algn="l" pos="3651120"/>
                <a:tab algn="l" pos="4381560"/>
                <a:tab algn="l" pos="5111640"/>
                <a:tab algn="l" pos="5842080"/>
                <a:tab algn="l" pos="6572160"/>
                <a:tab algn="l" pos="7302600"/>
                <a:tab algn="l" pos="8032680"/>
                <a:tab algn="l" pos="8763120"/>
                <a:tab algn="l" pos="9493200"/>
                <a:tab algn="l" pos="10223640"/>
                <a:tab algn="l" pos="10953720"/>
              </a:tabLst>
            </a:pPr>
            <a:r>
              <a:rPr b="0" lang="en-US" sz="51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5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639360" y="11864880"/>
            <a:ext cx="2987640" cy="681120"/>
          </a:xfrm>
          <a:prstGeom prst="rect">
            <a:avLst/>
          </a:prstGeom>
          <a:noFill/>
          <a:ln w="0">
            <a:noFill/>
          </a:ln>
        </p:spPr>
        <p:txBody>
          <a:bodyPr lIns="146160" rIns="146160" tIns="73080" bIns="73080" anchor="ctr">
            <a:noAutofit/>
          </a:bodyPr>
          <a:lstStyle>
            <a:lvl1pPr indent="0">
              <a:buNone/>
              <a:tabLst>
                <a:tab algn="l" pos="0"/>
                <a:tab algn="l" pos="730080"/>
                <a:tab algn="l" pos="1460520"/>
                <a:tab algn="l" pos="2190600"/>
                <a:tab algn="l" pos="2921040"/>
                <a:tab algn="l" pos="3651120"/>
                <a:tab algn="l" pos="4381560"/>
                <a:tab algn="l" pos="5111640"/>
                <a:tab algn="l" pos="5842080"/>
                <a:tab algn="l" pos="6572160"/>
                <a:tab algn="l" pos="7302600"/>
                <a:tab algn="l" pos="8032680"/>
                <a:tab algn="l" pos="8763120"/>
                <a:tab algn="l" pos="9493200"/>
                <a:tab algn="l" pos="10223640"/>
                <a:tab algn="l" pos="10953720"/>
              </a:tabLst>
              <a:defRPr b="0" lang="en-US" sz="19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730080"/>
                <a:tab algn="l" pos="1460520"/>
                <a:tab algn="l" pos="2190600"/>
                <a:tab algn="l" pos="2921040"/>
                <a:tab algn="l" pos="3651120"/>
                <a:tab algn="l" pos="4381560"/>
                <a:tab algn="l" pos="5111640"/>
                <a:tab algn="l" pos="5842080"/>
                <a:tab algn="l" pos="6572160"/>
                <a:tab algn="l" pos="7302600"/>
                <a:tab algn="l" pos="8032680"/>
                <a:tab algn="l" pos="8763120"/>
                <a:tab algn="l" pos="9493200"/>
                <a:tab algn="l" pos="10223640"/>
                <a:tab algn="l" pos="10953720"/>
              </a:tabLst>
            </a:pPr>
            <a:r>
              <a:rPr b="0" lang="en-US" sz="19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4373640" y="11864880"/>
            <a:ext cx="4054320" cy="681120"/>
          </a:xfrm>
          <a:prstGeom prst="rect">
            <a:avLst/>
          </a:prstGeom>
          <a:noFill/>
          <a:ln w="0">
            <a:noFill/>
          </a:ln>
        </p:spPr>
        <p:txBody>
          <a:bodyPr lIns="146160" rIns="146160" tIns="73080" bIns="73080" anchor="ctr">
            <a:noAutofit/>
          </a:bodyPr>
          <a:p>
            <a:pPr indent="0">
              <a:buNone/>
              <a:tabLst>
                <a:tab algn="l" pos="0"/>
                <a:tab algn="l" pos="730080"/>
                <a:tab algn="l" pos="1460520"/>
                <a:tab algn="l" pos="2190600"/>
                <a:tab algn="l" pos="2921040"/>
                <a:tab algn="l" pos="3651120"/>
                <a:tab algn="l" pos="4381560"/>
                <a:tab algn="l" pos="5111640"/>
                <a:tab algn="l" pos="5842080"/>
                <a:tab algn="l" pos="6572160"/>
                <a:tab algn="l" pos="7302600"/>
                <a:tab algn="l" pos="8032680"/>
                <a:tab algn="l" pos="8763120"/>
                <a:tab algn="l" pos="9493200"/>
                <a:tab algn="l" pos="10223640"/>
                <a:tab algn="l" pos="10953720"/>
              </a:tabLst>
            </a:pPr>
            <a:endParaRPr b="0" lang="en-US" sz="2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9173880" y="11864880"/>
            <a:ext cx="2987640" cy="681120"/>
          </a:xfrm>
          <a:prstGeom prst="rect">
            <a:avLst/>
          </a:prstGeom>
          <a:noFill/>
          <a:ln w="0">
            <a:noFill/>
          </a:ln>
        </p:spPr>
        <p:txBody>
          <a:bodyPr lIns="146160" rIns="146160" tIns="73080" bIns="73080" anchor="ctr">
            <a:noAutofit/>
          </a:bodyPr>
          <a:lstStyle>
            <a:lvl1pPr indent="0" algn="r">
              <a:buNone/>
              <a:tabLst>
                <a:tab algn="l" pos="0"/>
                <a:tab algn="l" pos="730080"/>
                <a:tab algn="l" pos="1460520"/>
                <a:tab algn="l" pos="2190600"/>
                <a:tab algn="l" pos="2921040"/>
                <a:tab algn="l" pos="3651120"/>
                <a:tab algn="l" pos="4381560"/>
                <a:tab algn="l" pos="5111640"/>
                <a:tab algn="l" pos="5842080"/>
                <a:tab algn="l" pos="6572160"/>
                <a:tab algn="l" pos="7302600"/>
                <a:tab algn="l" pos="8032680"/>
                <a:tab algn="l" pos="8763120"/>
                <a:tab algn="l" pos="9493200"/>
                <a:tab algn="l" pos="10223640"/>
                <a:tab algn="l" pos="10953720"/>
              </a:tabLst>
              <a:defRPr b="0" lang="en-US" sz="19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730080"/>
                <a:tab algn="l" pos="1460520"/>
                <a:tab algn="l" pos="2190600"/>
                <a:tab algn="l" pos="2921040"/>
                <a:tab algn="l" pos="3651120"/>
                <a:tab algn="l" pos="4381560"/>
                <a:tab algn="l" pos="5111640"/>
                <a:tab algn="l" pos="5842080"/>
                <a:tab algn="l" pos="6572160"/>
                <a:tab algn="l" pos="7302600"/>
                <a:tab algn="l" pos="8032680"/>
                <a:tab algn="l" pos="8763120"/>
                <a:tab algn="l" pos="9493200"/>
                <a:tab algn="l" pos="10223640"/>
                <a:tab algn="l" pos="10953720"/>
              </a:tabLst>
            </a:pPr>
            <a:fld id="{648408C7-2851-4B11-BE86-319DF1631CCE}" type="slidenum">
              <a:rPr b="0" lang="en-US" sz="19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9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image" Target="../media/image4.png"/><Relationship Id="rId5" Type="http://schemas.openxmlformats.org/officeDocument/2006/relationships/image" Target="../media/image5.png"/><Relationship Id="rId6" Type="http://schemas.openxmlformats.org/officeDocument/2006/relationships/image" Target="../media/image6.png"/><Relationship Id="rId7" Type="http://schemas.openxmlformats.org/officeDocument/2006/relationships/slideLayout" Target="../slideLayouts/slideLayout1.xml"/><Relationship Id="rId8" Type="http://schemas.openxmlformats.org/officeDocument/2006/relationships/notesSlide" Target="../notesSlides/notesSlide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8" name="Group 3"/>
          <p:cNvGrpSpPr/>
          <p:nvPr/>
        </p:nvGrpSpPr>
        <p:grpSpPr>
          <a:xfrm>
            <a:off x="932760" y="1260360"/>
            <a:ext cx="11251440" cy="10065960"/>
            <a:chOff x="932760" y="1260360"/>
            <a:chExt cx="11251440" cy="10065960"/>
          </a:xfrm>
        </p:grpSpPr>
        <p:sp>
          <p:nvSpPr>
            <p:cNvPr id="49" name="Rettangolo 62"/>
            <p:cNvSpPr/>
            <p:nvPr/>
          </p:nvSpPr>
          <p:spPr>
            <a:xfrm>
              <a:off x="982440" y="1260360"/>
              <a:ext cx="10793520" cy="873144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730080"/>
                  <a:tab algn="l" pos="1460520"/>
                  <a:tab algn="l" pos="2190600"/>
                  <a:tab algn="l" pos="2921040"/>
                  <a:tab algn="l" pos="3651120"/>
                  <a:tab algn="l" pos="4381560"/>
                  <a:tab algn="l" pos="5111640"/>
                  <a:tab algn="l" pos="5842080"/>
                  <a:tab algn="l" pos="6572160"/>
                  <a:tab algn="l" pos="7302600"/>
                  <a:tab algn="l" pos="8032680"/>
                  <a:tab algn="l" pos="8763120"/>
                  <a:tab algn="l" pos="9493200"/>
                  <a:tab algn="l" pos="10223640"/>
                  <a:tab algn="l" pos="10953720"/>
                </a:tabLst>
              </a:pPr>
              <a:endParaRPr b="0" lang="en-US" sz="29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pic>
          <p:nvPicPr>
            <p:cNvPr id="50" name="Grafico 1" descr=""/>
            <p:cNvPicPr/>
            <p:nvPr/>
          </p:nvPicPr>
          <p:blipFill>
            <a:blip r:embed="rId1"/>
            <a:stretch/>
          </p:blipFill>
          <p:spPr>
            <a:xfrm>
              <a:off x="1431360" y="5553360"/>
              <a:ext cx="5367240" cy="576648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51" name="TextBox 21"/>
            <p:cNvSpPr/>
            <p:nvPr/>
          </p:nvSpPr>
          <p:spPr>
            <a:xfrm>
              <a:off x="932760" y="5496480"/>
              <a:ext cx="30888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730080"/>
                  <a:tab algn="l" pos="1460520"/>
                  <a:tab algn="l" pos="2190600"/>
                  <a:tab algn="l" pos="2921040"/>
                  <a:tab algn="l" pos="3651120"/>
                  <a:tab algn="l" pos="4381560"/>
                  <a:tab algn="l" pos="5111640"/>
                  <a:tab algn="l" pos="5842080"/>
                  <a:tab algn="l" pos="6572160"/>
                  <a:tab algn="l" pos="7302600"/>
                  <a:tab algn="l" pos="8032680"/>
                  <a:tab algn="l" pos="8763120"/>
                  <a:tab algn="l" pos="9493200"/>
                  <a:tab algn="l" pos="10223640"/>
                  <a:tab algn="l" pos="1095372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Arial"/>
                  <a:ea typeface="Arial"/>
                </a:rPr>
                <a:t>D</a:t>
              </a:r>
              <a:endParaRPr b="0" lang="en-US" sz="1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2" name="CasellaDiTesto 18"/>
            <p:cNvSpPr/>
            <p:nvPr/>
          </p:nvSpPr>
          <p:spPr>
            <a:xfrm rot="16200000">
              <a:off x="-299880" y="8610120"/>
              <a:ext cx="287604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730080"/>
                  <a:tab algn="l" pos="1460520"/>
                  <a:tab algn="l" pos="2190600"/>
                  <a:tab algn="l" pos="2921040"/>
                  <a:tab algn="l" pos="3651120"/>
                  <a:tab algn="l" pos="4381560"/>
                  <a:tab algn="l" pos="5111640"/>
                  <a:tab algn="l" pos="5842080"/>
                  <a:tab algn="l" pos="6572160"/>
                  <a:tab algn="l" pos="7302600"/>
                  <a:tab algn="l" pos="8032680"/>
                  <a:tab algn="l" pos="8763120"/>
                  <a:tab algn="l" pos="9493200"/>
                  <a:tab algn="l" pos="10223640"/>
                  <a:tab algn="l" pos="10953720"/>
                </a:tabLst>
              </a:pPr>
              <a:r>
                <a:rPr b="0" lang="it-IT" sz="1400" spc="-1" strike="noStrike">
                  <a:solidFill>
                    <a:srgbClr val="000000"/>
                  </a:solidFill>
                  <a:latin typeface="Arial"/>
                  <a:ea typeface="Arial"/>
                </a:rPr>
                <a:t>Cell density  (% of  untreated)</a:t>
              </a:r>
              <a:endParaRPr b="0" lang="en-US" sz="1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3" name="CasellaDiTesto 80"/>
            <p:cNvSpPr/>
            <p:nvPr/>
          </p:nvSpPr>
          <p:spPr>
            <a:xfrm>
              <a:off x="3413880" y="11019240"/>
              <a:ext cx="339120" cy="30708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730080"/>
                  <a:tab algn="l" pos="1460520"/>
                  <a:tab algn="l" pos="2190600"/>
                  <a:tab algn="l" pos="2921040"/>
                  <a:tab algn="l" pos="3651120"/>
                  <a:tab algn="l" pos="4381560"/>
                  <a:tab algn="l" pos="5111640"/>
                  <a:tab algn="l" pos="5842080"/>
                  <a:tab algn="l" pos="6572160"/>
                  <a:tab algn="l" pos="7302600"/>
                  <a:tab algn="l" pos="8032680"/>
                  <a:tab algn="l" pos="8763120"/>
                  <a:tab algn="l" pos="9493200"/>
                  <a:tab algn="l" pos="10223640"/>
                  <a:tab algn="l" pos="10953720"/>
                </a:tabLst>
              </a:pPr>
              <a:r>
                <a:rPr b="0" lang="it-IT" sz="1400" spc="-1" strike="noStrike">
                  <a:solidFill>
                    <a:srgbClr val="000000"/>
                  </a:solidFill>
                  <a:latin typeface="Arial"/>
                  <a:ea typeface="Arial"/>
                </a:rPr>
                <a:t>-7</a:t>
              </a:r>
              <a:endParaRPr b="0" lang="en-US" sz="1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4" name="CasellaDiTesto 81"/>
            <p:cNvSpPr/>
            <p:nvPr/>
          </p:nvSpPr>
          <p:spPr>
            <a:xfrm>
              <a:off x="4942080" y="11019240"/>
              <a:ext cx="339120" cy="30708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730080"/>
                  <a:tab algn="l" pos="1460520"/>
                  <a:tab algn="l" pos="2190600"/>
                  <a:tab algn="l" pos="2921040"/>
                  <a:tab algn="l" pos="3651120"/>
                  <a:tab algn="l" pos="4381560"/>
                  <a:tab algn="l" pos="5111640"/>
                  <a:tab algn="l" pos="5842080"/>
                  <a:tab algn="l" pos="6572160"/>
                  <a:tab algn="l" pos="7302600"/>
                  <a:tab algn="l" pos="8032680"/>
                  <a:tab algn="l" pos="8763120"/>
                  <a:tab algn="l" pos="9493200"/>
                  <a:tab algn="l" pos="10223640"/>
                  <a:tab algn="l" pos="10953720"/>
                </a:tabLst>
              </a:pPr>
              <a:r>
                <a:rPr b="0" lang="it-IT" sz="1400" spc="-1" strike="noStrike">
                  <a:solidFill>
                    <a:srgbClr val="000000"/>
                  </a:solidFill>
                  <a:latin typeface="Arial"/>
                  <a:ea typeface="Arial"/>
                </a:rPr>
                <a:t>-6</a:t>
              </a:r>
              <a:endParaRPr b="0" lang="en-US" sz="1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5" name="CasellaDiTesto 98"/>
            <p:cNvSpPr/>
            <p:nvPr/>
          </p:nvSpPr>
          <p:spPr>
            <a:xfrm>
              <a:off x="1272960" y="11019240"/>
              <a:ext cx="1122480" cy="30708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730080"/>
                  <a:tab algn="l" pos="1460520"/>
                  <a:tab algn="l" pos="2190600"/>
                  <a:tab algn="l" pos="2921040"/>
                  <a:tab algn="l" pos="3651120"/>
                  <a:tab algn="l" pos="4381560"/>
                  <a:tab algn="l" pos="5111640"/>
                  <a:tab algn="l" pos="5842080"/>
                  <a:tab algn="l" pos="6572160"/>
                  <a:tab algn="l" pos="7302600"/>
                  <a:tab algn="l" pos="8032680"/>
                  <a:tab algn="l" pos="8763120"/>
                  <a:tab algn="l" pos="9493200"/>
                  <a:tab algn="l" pos="10223640"/>
                  <a:tab algn="l" pos="10953720"/>
                </a:tabLst>
              </a:pPr>
              <a:r>
                <a:rPr b="0" lang="it-IT" sz="1400" spc="-1" strike="noStrike">
                  <a:solidFill>
                    <a:srgbClr val="000000"/>
                  </a:solidFill>
                  <a:latin typeface="Arial"/>
                  <a:ea typeface="Arial"/>
                </a:rPr>
                <a:t>S1P (log M)</a:t>
              </a:r>
              <a:endParaRPr b="0" lang="en-US" sz="1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6" name="CasellaDiTesto 81"/>
            <p:cNvSpPr/>
            <p:nvPr/>
          </p:nvSpPr>
          <p:spPr>
            <a:xfrm>
              <a:off x="6455160" y="11019240"/>
              <a:ext cx="339120" cy="30708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730080"/>
                  <a:tab algn="l" pos="1460520"/>
                  <a:tab algn="l" pos="2190600"/>
                  <a:tab algn="l" pos="2921040"/>
                  <a:tab algn="l" pos="3651120"/>
                  <a:tab algn="l" pos="4381560"/>
                  <a:tab algn="l" pos="5111640"/>
                  <a:tab algn="l" pos="5842080"/>
                  <a:tab algn="l" pos="6572160"/>
                  <a:tab algn="l" pos="7302600"/>
                  <a:tab algn="l" pos="8032680"/>
                  <a:tab algn="l" pos="8763120"/>
                  <a:tab algn="l" pos="9493200"/>
                  <a:tab algn="l" pos="10223640"/>
                  <a:tab algn="l" pos="10953720"/>
                </a:tabLst>
              </a:pPr>
              <a:r>
                <a:rPr b="0" lang="it-IT" sz="1400" spc="-1" strike="noStrike">
                  <a:solidFill>
                    <a:srgbClr val="000000"/>
                  </a:solidFill>
                  <a:latin typeface="Arial"/>
                  <a:ea typeface="Arial"/>
                </a:rPr>
                <a:t>-5</a:t>
              </a:r>
              <a:endParaRPr b="0" lang="en-US" sz="1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pic>
          <p:nvPicPr>
            <p:cNvPr id="57" name="Picture 51" descr=""/>
            <p:cNvPicPr/>
            <p:nvPr/>
          </p:nvPicPr>
          <p:blipFill>
            <a:blip r:embed="rId2"/>
            <a:srcRect l="6779" t="17609" r="55086" b="23716"/>
            <a:stretch/>
          </p:blipFill>
          <p:spPr>
            <a:xfrm rot="21431400">
              <a:off x="9334800" y="5961240"/>
              <a:ext cx="1855080" cy="89892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58" name="CasellaDiTesto 1"/>
            <p:cNvSpPr/>
            <p:nvPr/>
          </p:nvSpPr>
          <p:spPr>
            <a:xfrm>
              <a:off x="10119240" y="5502600"/>
              <a:ext cx="555840" cy="52020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730080"/>
                  <a:tab algn="l" pos="1460520"/>
                  <a:tab algn="l" pos="2190600"/>
                  <a:tab algn="l" pos="2921040"/>
                  <a:tab algn="l" pos="3651120"/>
                  <a:tab algn="l" pos="4381560"/>
                  <a:tab algn="l" pos="5111640"/>
                  <a:tab algn="l" pos="5842080"/>
                  <a:tab algn="l" pos="6572160"/>
                  <a:tab algn="l" pos="7302600"/>
                  <a:tab algn="l" pos="8032680"/>
                  <a:tab algn="l" pos="8763120"/>
                  <a:tab algn="l" pos="9493200"/>
                  <a:tab algn="l" pos="10223640"/>
                  <a:tab algn="l" pos="10953720"/>
                </a:tabLst>
              </a:pPr>
              <a:r>
                <a:rPr b="0" lang="it-IT" sz="1400" spc="-1" strike="noStrike">
                  <a:solidFill>
                    <a:srgbClr val="000000"/>
                  </a:solidFill>
                  <a:latin typeface="Arial"/>
                  <a:ea typeface="Arial"/>
                </a:rPr>
                <a:t>5</a:t>
              </a:r>
              <a:r>
                <a:rPr b="0" lang="it-IT" sz="1400" spc="-1" strike="noStrike">
                  <a:solidFill>
                    <a:srgbClr val="000000"/>
                  </a:solidFill>
                  <a:latin typeface="Symbol"/>
                  <a:ea typeface="Symbol"/>
                </a:rPr>
                <a:t></a:t>
              </a:r>
              <a:r>
                <a:rPr b="0" lang="it-IT" sz="1400" spc="-1" strike="noStrike">
                  <a:solidFill>
                    <a:srgbClr val="000000"/>
                  </a:solidFill>
                  <a:latin typeface="Arial"/>
                  <a:ea typeface="Arial"/>
                </a:rPr>
                <a:t>M BK</a:t>
              </a:r>
              <a:endParaRPr b="0" lang="en-US" sz="1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9" name="Straight Connector 33"/>
            <p:cNvSpPr/>
            <p:nvPr/>
          </p:nvSpPr>
          <p:spPr>
            <a:xfrm>
              <a:off x="10139040" y="6086520"/>
              <a:ext cx="51624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9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0" name="CasellaDiTesto 1"/>
            <p:cNvSpPr/>
            <p:nvPr/>
          </p:nvSpPr>
          <p:spPr>
            <a:xfrm>
              <a:off x="10705320" y="5502600"/>
              <a:ext cx="555840" cy="52020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730080"/>
                  <a:tab algn="l" pos="1460520"/>
                  <a:tab algn="l" pos="2190600"/>
                  <a:tab algn="l" pos="2921040"/>
                  <a:tab algn="l" pos="3651120"/>
                  <a:tab algn="l" pos="4381560"/>
                  <a:tab algn="l" pos="5111640"/>
                  <a:tab algn="l" pos="5842080"/>
                  <a:tab algn="l" pos="6572160"/>
                  <a:tab algn="l" pos="7302600"/>
                  <a:tab algn="l" pos="8032680"/>
                  <a:tab algn="l" pos="8763120"/>
                  <a:tab algn="l" pos="9493200"/>
                  <a:tab algn="l" pos="10223640"/>
                  <a:tab algn="l" pos="10953720"/>
                </a:tabLst>
              </a:pPr>
              <a:r>
                <a:rPr b="0" lang="it-IT" sz="1400" spc="-1" strike="noStrike">
                  <a:solidFill>
                    <a:srgbClr val="000000"/>
                  </a:solidFill>
                  <a:latin typeface="Arial"/>
                  <a:ea typeface="Arial"/>
                </a:rPr>
                <a:t>5</a:t>
              </a:r>
              <a:r>
                <a:rPr b="0" lang="it-IT" sz="1400" spc="-1" strike="noStrike">
                  <a:solidFill>
                    <a:srgbClr val="000000"/>
                  </a:solidFill>
                  <a:latin typeface="Symbol"/>
                  <a:ea typeface="Symbol"/>
                </a:rPr>
                <a:t></a:t>
              </a:r>
              <a:r>
                <a:rPr b="0" lang="it-IT" sz="1400" spc="-1" strike="noStrike">
                  <a:solidFill>
                    <a:srgbClr val="000000"/>
                  </a:solidFill>
                  <a:latin typeface="Arial"/>
                  <a:ea typeface="Arial"/>
                </a:rPr>
                <a:t>M</a:t>
              </a:r>
              <a:endParaRPr b="0" lang="en-US" sz="1400" spc="-1" strike="noStrike">
                <a:solidFill>
                  <a:srgbClr val="000000"/>
                </a:solidFill>
                <a:latin typeface="Calibri"/>
              </a:endParaRPr>
            </a:p>
            <a:p>
              <a:pPr algn="ctr">
                <a:lnSpc>
                  <a:spcPct val="100000"/>
                </a:lnSpc>
                <a:tabLst>
                  <a:tab algn="l" pos="0"/>
                  <a:tab algn="l" pos="730080"/>
                  <a:tab algn="l" pos="1460520"/>
                  <a:tab algn="l" pos="2190600"/>
                  <a:tab algn="l" pos="2921040"/>
                  <a:tab algn="l" pos="3651120"/>
                  <a:tab algn="l" pos="4381560"/>
                  <a:tab algn="l" pos="5111640"/>
                  <a:tab algn="l" pos="5842080"/>
                  <a:tab algn="l" pos="6572160"/>
                  <a:tab algn="l" pos="7302600"/>
                  <a:tab algn="l" pos="8032680"/>
                  <a:tab algn="l" pos="8763120"/>
                  <a:tab algn="l" pos="9493200"/>
                  <a:tab algn="l" pos="10223640"/>
                  <a:tab algn="l" pos="10953720"/>
                </a:tabLst>
              </a:pPr>
              <a:r>
                <a:rPr b="0" lang="it-IT" sz="1400" spc="-1" strike="noStrike">
                  <a:solidFill>
                    <a:srgbClr val="000000"/>
                  </a:solidFill>
                  <a:latin typeface="Arial"/>
                  <a:ea typeface="Arial"/>
                </a:rPr>
                <a:t>S1P</a:t>
              </a:r>
              <a:endParaRPr b="0" lang="en-US" sz="1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1" name="Straight Connector 33"/>
            <p:cNvSpPr/>
            <p:nvPr/>
          </p:nvSpPr>
          <p:spPr>
            <a:xfrm>
              <a:off x="10725120" y="6086520"/>
              <a:ext cx="51624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9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2" name="CasellaDiTesto 1"/>
            <p:cNvSpPr/>
            <p:nvPr/>
          </p:nvSpPr>
          <p:spPr>
            <a:xfrm>
              <a:off x="9497160" y="5629680"/>
              <a:ext cx="555840" cy="30708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730080"/>
                  <a:tab algn="l" pos="1460520"/>
                  <a:tab algn="l" pos="2190600"/>
                  <a:tab algn="l" pos="2921040"/>
                  <a:tab algn="l" pos="3651120"/>
                  <a:tab algn="l" pos="4381560"/>
                  <a:tab algn="l" pos="5111640"/>
                  <a:tab algn="l" pos="5842080"/>
                  <a:tab algn="l" pos="6572160"/>
                  <a:tab algn="l" pos="7302600"/>
                  <a:tab algn="l" pos="8032680"/>
                  <a:tab algn="l" pos="8763120"/>
                  <a:tab algn="l" pos="9493200"/>
                  <a:tab algn="l" pos="10223640"/>
                  <a:tab algn="l" pos="10953720"/>
                </a:tabLst>
              </a:pPr>
              <a:r>
                <a:rPr b="0" lang="it-IT" sz="1400" spc="-1" strike="noStrike">
                  <a:solidFill>
                    <a:srgbClr val="000000"/>
                  </a:solidFill>
                  <a:latin typeface="Arial"/>
                  <a:ea typeface="Arial"/>
                </a:rPr>
                <a:t>-</a:t>
              </a:r>
              <a:endParaRPr b="0" lang="en-US" sz="1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3" name="Straight Connector 33"/>
            <p:cNvSpPr/>
            <p:nvPr/>
          </p:nvSpPr>
          <p:spPr>
            <a:xfrm>
              <a:off x="9516960" y="6086520"/>
              <a:ext cx="51624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9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4" name="CasellaDiTesto 299"/>
            <p:cNvSpPr/>
            <p:nvPr/>
          </p:nvSpPr>
          <p:spPr>
            <a:xfrm>
              <a:off x="7220880" y="6236640"/>
              <a:ext cx="2084040" cy="31680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146160" rIns="146160" tIns="73080" bIns="73080" anchor="t">
              <a:spAutoFit/>
            </a:bodyPr>
            <a:p>
              <a:pPr algn="r">
                <a:lnSpc>
                  <a:spcPct val="80000"/>
                </a:lnSpc>
                <a:tabLst>
                  <a:tab algn="l" pos="0"/>
                  <a:tab algn="l" pos="730080"/>
                  <a:tab algn="l" pos="1460520"/>
                  <a:tab algn="l" pos="2190600"/>
                  <a:tab algn="l" pos="2921040"/>
                  <a:tab algn="l" pos="3651120"/>
                  <a:tab algn="l" pos="4381560"/>
                  <a:tab algn="l" pos="5111640"/>
                  <a:tab algn="l" pos="5842080"/>
                  <a:tab algn="l" pos="6572160"/>
                  <a:tab algn="l" pos="7302600"/>
                  <a:tab algn="l" pos="8032680"/>
                  <a:tab algn="l" pos="8763120"/>
                  <a:tab algn="l" pos="9493200"/>
                  <a:tab algn="l" pos="10223640"/>
                  <a:tab algn="l" pos="10953720"/>
                </a:tabLst>
              </a:pPr>
              <a:r>
                <a:rPr b="0" lang="it-IT" sz="1400" spc="-1" strike="noStrike">
                  <a:solidFill>
                    <a:srgbClr val="000000"/>
                  </a:solidFill>
                  <a:latin typeface="Arial"/>
                  <a:ea typeface="Arial"/>
                </a:rPr>
                <a:t>phospho-ERK1/2 </a:t>
              </a:r>
              <a:r>
                <a:rPr b="0" lang="it-IT" sz="1400" spc="-1" strike="noStrike">
                  <a:solidFill>
                    <a:srgbClr val="000000"/>
                  </a:solidFill>
                  <a:latin typeface="Wingdings"/>
                  <a:ea typeface="Wingdings"/>
                </a:rPr>
                <a:t></a:t>
              </a:r>
              <a:endParaRPr b="0" lang="en-US" sz="1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5" name="TextBox 60"/>
            <p:cNvSpPr/>
            <p:nvPr/>
          </p:nvSpPr>
          <p:spPr>
            <a:xfrm>
              <a:off x="6968880" y="5509080"/>
              <a:ext cx="29952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730080"/>
                  <a:tab algn="l" pos="1460520"/>
                  <a:tab algn="l" pos="2190600"/>
                  <a:tab algn="l" pos="2921040"/>
                  <a:tab algn="l" pos="3651120"/>
                  <a:tab algn="l" pos="4381560"/>
                  <a:tab algn="l" pos="5111640"/>
                  <a:tab algn="l" pos="5842080"/>
                  <a:tab algn="l" pos="6572160"/>
                  <a:tab algn="l" pos="7302600"/>
                  <a:tab algn="l" pos="8032680"/>
                  <a:tab algn="l" pos="8763120"/>
                  <a:tab algn="l" pos="9493200"/>
                  <a:tab algn="l" pos="10223640"/>
                  <a:tab algn="l" pos="1095372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Arial"/>
                  <a:ea typeface="Arial"/>
                </a:rPr>
                <a:t>E</a:t>
              </a:r>
              <a:endParaRPr b="0" lang="en-US" sz="1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6" name="CasellaDiTesto 2"/>
            <p:cNvSpPr/>
            <p:nvPr/>
          </p:nvSpPr>
          <p:spPr>
            <a:xfrm>
              <a:off x="5329080" y="6113520"/>
              <a:ext cx="99468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730080"/>
                  <a:tab algn="l" pos="1460520"/>
                  <a:tab algn="l" pos="2190600"/>
                  <a:tab algn="l" pos="2921040"/>
                  <a:tab algn="l" pos="3651120"/>
                  <a:tab algn="l" pos="4381560"/>
                  <a:tab algn="l" pos="5111640"/>
                  <a:tab algn="l" pos="5842080"/>
                  <a:tab algn="l" pos="6572160"/>
                  <a:tab algn="l" pos="7302600"/>
                  <a:tab algn="l" pos="8032680"/>
                  <a:tab algn="l" pos="8763120"/>
                  <a:tab algn="l" pos="9493200"/>
                  <a:tab algn="l" pos="10223640"/>
                  <a:tab algn="l" pos="10953720"/>
                </a:tabLst>
              </a:pPr>
              <a:r>
                <a:rPr b="0" lang="it-IT" sz="1400" spc="-1" strike="noStrike">
                  <a:solidFill>
                    <a:srgbClr val="000000"/>
                  </a:solidFill>
                  <a:latin typeface="Arial"/>
                  <a:ea typeface="Arial"/>
                </a:rPr>
                <a:t>GMZ (</a:t>
              </a:r>
              <a:r>
                <a:rPr b="0" lang="it-IT" sz="1400" spc="-1" strike="noStrike">
                  <a:solidFill>
                    <a:srgbClr val="000000"/>
                  </a:solidFill>
                  <a:latin typeface="Symbol"/>
                  <a:ea typeface="Symbol"/>
                </a:rPr>
                <a:t></a:t>
              </a:r>
              <a:r>
                <a:rPr b="0" lang="it-IT" sz="1400" spc="-1" strike="noStrike">
                  <a:solidFill>
                    <a:srgbClr val="000000"/>
                  </a:solidFill>
                  <a:latin typeface="Arial"/>
                  <a:ea typeface="Arial"/>
                </a:rPr>
                <a:t>M)</a:t>
              </a:r>
              <a:endParaRPr b="0" lang="en-US" sz="1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pic>
          <p:nvPicPr>
            <p:cNvPr id="67" name="Chart 48" descr=""/>
            <p:cNvPicPr/>
            <p:nvPr/>
          </p:nvPicPr>
          <p:blipFill>
            <a:blip r:embed="rId3"/>
            <a:stretch/>
          </p:blipFill>
          <p:spPr>
            <a:xfrm>
              <a:off x="7468920" y="6431400"/>
              <a:ext cx="4715280" cy="480924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68" name="CasellaDiTesto 18"/>
            <p:cNvSpPr/>
            <p:nvPr/>
          </p:nvSpPr>
          <p:spPr>
            <a:xfrm rot="16200000">
              <a:off x="5912640" y="8589600"/>
              <a:ext cx="287604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730080"/>
                  <a:tab algn="l" pos="1460520"/>
                  <a:tab algn="l" pos="2190600"/>
                  <a:tab algn="l" pos="2921040"/>
                  <a:tab algn="l" pos="3651120"/>
                  <a:tab algn="l" pos="4381560"/>
                  <a:tab algn="l" pos="5111640"/>
                  <a:tab algn="l" pos="5842080"/>
                  <a:tab algn="l" pos="6572160"/>
                  <a:tab algn="l" pos="7302600"/>
                  <a:tab algn="l" pos="8032680"/>
                  <a:tab algn="l" pos="8763120"/>
                  <a:tab algn="l" pos="9493200"/>
                  <a:tab algn="l" pos="10223640"/>
                  <a:tab algn="l" pos="10953720"/>
                </a:tabLst>
              </a:pPr>
              <a:r>
                <a:rPr b="0" lang="it-IT" sz="1400" spc="-1" strike="noStrike">
                  <a:solidFill>
                    <a:srgbClr val="000000"/>
                  </a:solidFill>
                  <a:latin typeface="Arial"/>
                  <a:ea typeface="Arial"/>
                </a:rPr>
                <a:t>Cell density  (% of  untreated)</a:t>
              </a:r>
              <a:endParaRPr b="0" lang="en-US" sz="1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9" name="CasellaDiTesto 42"/>
            <p:cNvSpPr/>
            <p:nvPr/>
          </p:nvSpPr>
          <p:spPr>
            <a:xfrm>
              <a:off x="9839880" y="10679400"/>
              <a:ext cx="625680" cy="30708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730080"/>
                  <a:tab algn="l" pos="1460520"/>
                  <a:tab algn="l" pos="2190600"/>
                  <a:tab algn="l" pos="2921040"/>
                  <a:tab algn="l" pos="3651120"/>
                  <a:tab algn="l" pos="4381560"/>
                  <a:tab algn="l" pos="5111640"/>
                  <a:tab algn="l" pos="5842080"/>
                  <a:tab algn="l" pos="6572160"/>
                  <a:tab algn="l" pos="7302600"/>
                  <a:tab algn="l" pos="8032680"/>
                  <a:tab algn="l" pos="8763120"/>
                  <a:tab algn="l" pos="9493200"/>
                  <a:tab algn="l" pos="10223640"/>
                  <a:tab algn="l" pos="10953720"/>
                </a:tabLst>
              </a:pPr>
              <a:r>
                <a:rPr b="0" lang="it-IT" sz="1400" spc="-1" strike="noStrike">
                  <a:solidFill>
                    <a:srgbClr val="000000"/>
                  </a:solidFill>
                  <a:latin typeface="Arial"/>
                  <a:ea typeface="Arial"/>
                </a:rPr>
                <a:t>10nM</a:t>
              </a:r>
              <a:endParaRPr b="0" lang="en-US" sz="1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0" name="CasellaDiTesto 43"/>
            <p:cNvSpPr/>
            <p:nvPr/>
          </p:nvSpPr>
          <p:spPr>
            <a:xfrm>
              <a:off x="10633680" y="10679400"/>
              <a:ext cx="529920" cy="30708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730080"/>
                  <a:tab algn="l" pos="1460520"/>
                  <a:tab algn="l" pos="2190600"/>
                  <a:tab algn="l" pos="2921040"/>
                  <a:tab algn="l" pos="3651120"/>
                  <a:tab algn="l" pos="4381560"/>
                  <a:tab algn="l" pos="5111640"/>
                  <a:tab algn="l" pos="5842080"/>
                  <a:tab algn="l" pos="6572160"/>
                  <a:tab algn="l" pos="7302600"/>
                  <a:tab algn="l" pos="8032680"/>
                  <a:tab algn="l" pos="8763120"/>
                  <a:tab algn="l" pos="9493200"/>
                  <a:tab algn="l" pos="10223640"/>
                  <a:tab algn="l" pos="10953720"/>
                </a:tabLst>
              </a:pPr>
              <a:r>
                <a:rPr b="0" lang="it-IT" sz="1400" spc="-1" strike="noStrike">
                  <a:solidFill>
                    <a:srgbClr val="000000"/>
                  </a:solidFill>
                  <a:latin typeface="Arial"/>
                  <a:ea typeface="Arial"/>
                </a:rPr>
                <a:t>1</a:t>
              </a:r>
              <a:r>
                <a:rPr b="0" lang="it-IT" sz="1400" spc="-1" strike="noStrike">
                  <a:solidFill>
                    <a:srgbClr val="000000"/>
                  </a:solidFill>
                  <a:latin typeface="Symbol"/>
                  <a:ea typeface="Symbol"/>
                </a:rPr>
                <a:t></a:t>
              </a:r>
              <a:r>
                <a:rPr b="0" lang="it-IT" sz="1400" spc="-1" strike="noStrike">
                  <a:solidFill>
                    <a:srgbClr val="000000"/>
                  </a:solidFill>
                  <a:latin typeface="Arial"/>
                  <a:ea typeface="Arial"/>
                </a:rPr>
                <a:t>M</a:t>
              </a:r>
              <a:endParaRPr b="0" lang="en-US" sz="1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1" name="CasellaDiTesto 44"/>
            <p:cNvSpPr/>
            <p:nvPr/>
          </p:nvSpPr>
          <p:spPr>
            <a:xfrm>
              <a:off x="11387880" y="10679400"/>
              <a:ext cx="529920" cy="30708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730080"/>
                  <a:tab algn="l" pos="1460520"/>
                  <a:tab algn="l" pos="2190600"/>
                  <a:tab algn="l" pos="2921040"/>
                  <a:tab algn="l" pos="3651120"/>
                  <a:tab algn="l" pos="4381560"/>
                  <a:tab algn="l" pos="5111640"/>
                  <a:tab algn="l" pos="5842080"/>
                  <a:tab algn="l" pos="6572160"/>
                  <a:tab algn="l" pos="7302600"/>
                  <a:tab algn="l" pos="8032680"/>
                  <a:tab algn="l" pos="8763120"/>
                  <a:tab algn="l" pos="9493200"/>
                  <a:tab algn="l" pos="10223640"/>
                  <a:tab algn="l" pos="10953720"/>
                </a:tabLst>
              </a:pPr>
              <a:r>
                <a:rPr b="0" lang="it-IT" sz="1400" spc="-1" strike="noStrike">
                  <a:solidFill>
                    <a:srgbClr val="000000"/>
                  </a:solidFill>
                  <a:latin typeface="Arial"/>
                  <a:ea typeface="Arial"/>
                </a:rPr>
                <a:t>5</a:t>
              </a:r>
              <a:r>
                <a:rPr b="0" lang="it-IT" sz="1400" spc="-1" strike="noStrike">
                  <a:solidFill>
                    <a:srgbClr val="000000"/>
                  </a:solidFill>
                  <a:latin typeface="Symbol"/>
                  <a:ea typeface="Symbol"/>
                </a:rPr>
                <a:t></a:t>
              </a:r>
              <a:r>
                <a:rPr b="0" lang="it-IT" sz="1400" spc="-1" strike="noStrike">
                  <a:solidFill>
                    <a:srgbClr val="000000"/>
                  </a:solidFill>
                  <a:latin typeface="Arial"/>
                  <a:ea typeface="Arial"/>
                </a:rPr>
                <a:t>M</a:t>
              </a:r>
              <a:endParaRPr b="0" lang="en-US" sz="1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2" name="CasellaDiTesto 45"/>
            <p:cNvSpPr/>
            <p:nvPr/>
          </p:nvSpPr>
          <p:spPr>
            <a:xfrm>
              <a:off x="10664640" y="11006640"/>
              <a:ext cx="468720" cy="30708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730080"/>
                  <a:tab algn="l" pos="1460520"/>
                  <a:tab algn="l" pos="2190600"/>
                  <a:tab algn="l" pos="2921040"/>
                  <a:tab algn="l" pos="3651120"/>
                  <a:tab algn="l" pos="4381560"/>
                  <a:tab algn="l" pos="5111640"/>
                  <a:tab algn="l" pos="5842080"/>
                  <a:tab algn="l" pos="6572160"/>
                  <a:tab algn="l" pos="7302600"/>
                  <a:tab algn="l" pos="8032680"/>
                  <a:tab algn="l" pos="8763120"/>
                  <a:tab algn="l" pos="9493200"/>
                  <a:tab algn="l" pos="10223640"/>
                  <a:tab algn="l" pos="1095372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  <a:ea typeface="Arial"/>
                </a:rPr>
                <a:t>BK </a:t>
              </a:r>
              <a:endParaRPr b="0" lang="en-US" sz="1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3" name="Straight Connector 33"/>
            <p:cNvSpPr/>
            <p:nvPr/>
          </p:nvSpPr>
          <p:spPr>
            <a:xfrm>
              <a:off x="9893520" y="11000160"/>
              <a:ext cx="201024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9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4" name="CasellaDiTesto 2"/>
            <p:cNvSpPr/>
            <p:nvPr/>
          </p:nvSpPr>
          <p:spPr>
            <a:xfrm>
              <a:off x="9142560" y="10680480"/>
              <a:ext cx="529920" cy="52020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730080"/>
                  <a:tab algn="l" pos="1460520"/>
                  <a:tab algn="l" pos="2190600"/>
                  <a:tab algn="l" pos="2921040"/>
                  <a:tab algn="l" pos="3651120"/>
                  <a:tab algn="l" pos="4381560"/>
                  <a:tab algn="l" pos="5111640"/>
                  <a:tab algn="l" pos="5842080"/>
                  <a:tab algn="l" pos="6572160"/>
                  <a:tab algn="l" pos="7302600"/>
                  <a:tab algn="l" pos="8032680"/>
                  <a:tab algn="l" pos="8763120"/>
                  <a:tab algn="l" pos="9493200"/>
                  <a:tab algn="l" pos="10223640"/>
                  <a:tab algn="l" pos="10953720"/>
                </a:tabLst>
              </a:pPr>
              <a:r>
                <a:rPr b="0" lang="it-IT" sz="1400" spc="-1" strike="noStrike">
                  <a:solidFill>
                    <a:srgbClr val="000000"/>
                  </a:solidFill>
                  <a:latin typeface="Arial"/>
                  <a:ea typeface="Arial"/>
                </a:rPr>
                <a:t>5</a:t>
              </a:r>
              <a:r>
                <a:rPr b="0" lang="it-IT" sz="1400" spc="-1" strike="noStrike">
                  <a:solidFill>
                    <a:srgbClr val="000000"/>
                  </a:solidFill>
                  <a:latin typeface="Symbol"/>
                  <a:ea typeface="Symbol"/>
                </a:rPr>
                <a:t></a:t>
              </a:r>
              <a:r>
                <a:rPr b="0" lang="it-IT" sz="1400" spc="-1" strike="noStrike">
                  <a:solidFill>
                    <a:srgbClr val="000000"/>
                  </a:solidFill>
                  <a:latin typeface="Arial"/>
                  <a:ea typeface="Arial"/>
                </a:rPr>
                <a:t>M</a:t>
              </a:r>
              <a:endParaRPr b="0" lang="en-US" sz="1400" spc="-1" strike="noStrike">
                <a:solidFill>
                  <a:srgbClr val="000000"/>
                </a:solidFill>
                <a:latin typeface="Calibri"/>
              </a:endParaRPr>
            </a:p>
            <a:p>
              <a:pPr algn="ctr">
                <a:lnSpc>
                  <a:spcPct val="100000"/>
                </a:lnSpc>
                <a:tabLst>
                  <a:tab algn="l" pos="0"/>
                  <a:tab algn="l" pos="730080"/>
                  <a:tab algn="l" pos="1460520"/>
                  <a:tab algn="l" pos="2190600"/>
                  <a:tab algn="l" pos="2921040"/>
                  <a:tab algn="l" pos="3651120"/>
                  <a:tab algn="l" pos="4381560"/>
                  <a:tab algn="l" pos="5111640"/>
                  <a:tab algn="l" pos="5842080"/>
                  <a:tab algn="l" pos="6572160"/>
                  <a:tab algn="l" pos="7302600"/>
                  <a:tab algn="l" pos="8032680"/>
                  <a:tab algn="l" pos="8763120"/>
                  <a:tab algn="l" pos="9493200"/>
                  <a:tab algn="l" pos="10223640"/>
                  <a:tab algn="l" pos="10953720"/>
                </a:tabLst>
              </a:pPr>
              <a:r>
                <a:rPr b="0" lang="it-IT" sz="1400" spc="-1" strike="noStrike">
                  <a:solidFill>
                    <a:srgbClr val="000000"/>
                  </a:solidFill>
                  <a:latin typeface="Arial"/>
                  <a:ea typeface="Arial"/>
                </a:rPr>
                <a:t>S1P</a:t>
              </a:r>
              <a:endParaRPr b="0" lang="en-US" sz="1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5" name="CasellaDiTesto 2"/>
            <p:cNvSpPr/>
            <p:nvPr/>
          </p:nvSpPr>
          <p:spPr>
            <a:xfrm>
              <a:off x="8537760" y="10656720"/>
              <a:ext cx="235440" cy="30708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tabLst>
                  <a:tab algn="l" pos="0"/>
                  <a:tab algn="l" pos="730080"/>
                  <a:tab algn="l" pos="1460520"/>
                  <a:tab algn="l" pos="2190600"/>
                  <a:tab algn="l" pos="2921040"/>
                  <a:tab algn="l" pos="3651120"/>
                  <a:tab algn="l" pos="4381560"/>
                  <a:tab algn="l" pos="5111640"/>
                  <a:tab algn="l" pos="5842080"/>
                  <a:tab algn="l" pos="6572160"/>
                  <a:tab algn="l" pos="7302600"/>
                  <a:tab algn="l" pos="8032680"/>
                  <a:tab algn="l" pos="8763120"/>
                  <a:tab algn="l" pos="9493200"/>
                  <a:tab algn="l" pos="10223640"/>
                  <a:tab algn="l" pos="10953720"/>
                </a:tabLst>
              </a:pPr>
              <a:r>
                <a:rPr b="0" lang="it-IT" sz="1400" spc="-1" strike="noStrike">
                  <a:solidFill>
                    <a:srgbClr val="000000"/>
                  </a:solidFill>
                  <a:latin typeface="Calibri"/>
                </a:rPr>
                <a:t>-</a:t>
              </a:r>
              <a:endParaRPr b="0" lang="en-US" sz="1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6" name="CasellaDiTesto 47"/>
            <p:cNvSpPr/>
            <p:nvPr/>
          </p:nvSpPr>
          <p:spPr>
            <a:xfrm>
              <a:off x="11190600" y="6236640"/>
              <a:ext cx="74016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730080"/>
                  <a:tab algn="l" pos="1460520"/>
                  <a:tab algn="l" pos="2190600"/>
                  <a:tab algn="l" pos="2921040"/>
                  <a:tab algn="l" pos="3651120"/>
                  <a:tab algn="l" pos="4381560"/>
                  <a:tab algn="l" pos="5111640"/>
                  <a:tab algn="l" pos="5842080"/>
                  <a:tab algn="l" pos="6572160"/>
                  <a:tab algn="l" pos="7302600"/>
                  <a:tab algn="l" pos="8032680"/>
                  <a:tab algn="l" pos="8763120"/>
                  <a:tab algn="l" pos="9493200"/>
                  <a:tab algn="l" pos="10223640"/>
                  <a:tab algn="l" pos="10953720"/>
                </a:tabLst>
              </a:pPr>
              <a:r>
                <a:rPr b="0" lang="it-IT" sz="1100" spc="-1" strike="noStrike">
                  <a:solidFill>
                    <a:srgbClr val="000000"/>
                  </a:solidFill>
                  <a:latin typeface="Calibri"/>
                </a:rPr>
                <a:t>44/42kDa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7" name="TextBox 63"/>
            <p:cNvSpPr/>
            <p:nvPr/>
          </p:nvSpPr>
          <p:spPr>
            <a:xfrm>
              <a:off x="1025640" y="1396440"/>
              <a:ext cx="30888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730080"/>
                  <a:tab algn="l" pos="1460520"/>
                  <a:tab algn="l" pos="2190600"/>
                  <a:tab algn="l" pos="2921040"/>
                  <a:tab algn="l" pos="3651120"/>
                  <a:tab algn="l" pos="4381560"/>
                  <a:tab algn="l" pos="5111640"/>
                  <a:tab algn="l" pos="5842080"/>
                  <a:tab algn="l" pos="6572160"/>
                  <a:tab algn="l" pos="7302600"/>
                  <a:tab algn="l" pos="8032680"/>
                  <a:tab algn="l" pos="8763120"/>
                  <a:tab algn="l" pos="9493200"/>
                  <a:tab algn="l" pos="10223640"/>
                  <a:tab algn="l" pos="1095372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Arial"/>
                  <a:ea typeface="Arial"/>
                </a:rPr>
                <a:t>A</a:t>
              </a:r>
              <a:endParaRPr b="0" lang="en-US" sz="1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pic>
          <p:nvPicPr>
            <p:cNvPr id="78" name="Chart 65" descr=""/>
            <p:cNvPicPr/>
            <p:nvPr/>
          </p:nvPicPr>
          <p:blipFill>
            <a:blip r:embed="rId4"/>
            <a:stretch/>
          </p:blipFill>
          <p:spPr>
            <a:xfrm>
              <a:off x="8931240" y="1585080"/>
              <a:ext cx="3241080" cy="360864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79" name="CasellaDiTesto 18"/>
            <p:cNvSpPr/>
            <p:nvPr/>
          </p:nvSpPr>
          <p:spPr>
            <a:xfrm rot="16200000">
              <a:off x="7201440" y="3154320"/>
              <a:ext cx="287604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730080"/>
                  <a:tab algn="l" pos="1460520"/>
                  <a:tab algn="l" pos="2190600"/>
                  <a:tab algn="l" pos="2921040"/>
                  <a:tab algn="l" pos="3651120"/>
                  <a:tab algn="l" pos="4381560"/>
                  <a:tab algn="l" pos="5111640"/>
                  <a:tab algn="l" pos="5842080"/>
                  <a:tab algn="l" pos="6572160"/>
                  <a:tab algn="l" pos="7302600"/>
                  <a:tab algn="l" pos="8032680"/>
                  <a:tab algn="l" pos="8763120"/>
                  <a:tab algn="l" pos="9493200"/>
                  <a:tab algn="l" pos="10223640"/>
                  <a:tab algn="l" pos="10953720"/>
                </a:tabLst>
              </a:pPr>
              <a:r>
                <a:rPr b="0" lang="it-IT" sz="1400" spc="-1" strike="noStrike">
                  <a:solidFill>
                    <a:srgbClr val="000000"/>
                  </a:solidFill>
                  <a:latin typeface="Arial"/>
                  <a:ea typeface="Arial"/>
                </a:rPr>
                <a:t>Cell density  (% of  untreated)</a:t>
              </a:r>
              <a:endParaRPr b="0" lang="en-US" sz="1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0" name="CasellaDiTesto 80"/>
            <p:cNvSpPr/>
            <p:nvPr/>
          </p:nvSpPr>
          <p:spPr>
            <a:xfrm>
              <a:off x="10204920" y="4868640"/>
              <a:ext cx="339120" cy="30708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730080"/>
                  <a:tab algn="l" pos="1460520"/>
                  <a:tab algn="l" pos="2190600"/>
                  <a:tab algn="l" pos="2921040"/>
                  <a:tab algn="l" pos="3651120"/>
                  <a:tab algn="l" pos="4381560"/>
                  <a:tab algn="l" pos="5111640"/>
                  <a:tab algn="l" pos="5842080"/>
                  <a:tab algn="l" pos="6572160"/>
                  <a:tab algn="l" pos="7302600"/>
                  <a:tab algn="l" pos="8032680"/>
                  <a:tab algn="l" pos="8763120"/>
                  <a:tab algn="l" pos="9493200"/>
                  <a:tab algn="l" pos="10223640"/>
                  <a:tab algn="l" pos="10953720"/>
                </a:tabLst>
              </a:pPr>
              <a:r>
                <a:rPr b="0" lang="it-IT" sz="1400" spc="-1" strike="noStrike">
                  <a:solidFill>
                    <a:srgbClr val="000000"/>
                  </a:solidFill>
                  <a:latin typeface="Arial"/>
                  <a:ea typeface="Arial"/>
                </a:rPr>
                <a:t>-7</a:t>
              </a:r>
              <a:endParaRPr b="0" lang="en-US" sz="1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1" name="CasellaDiTesto 81"/>
            <p:cNvSpPr/>
            <p:nvPr/>
          </p:nvSpPr>
          <p:spPr>
            <a:xfrm>
              <a:off x="11013120" y="4868640"/>
              <a:ext cx="339120" cy="30708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730080"/>
                  <a:tab algn="l" pos="1460520"/>
                  <a:tab algn="l" pos="2190600"/>
                  <a:tab algn="l" pos="2921040"/>
                  <a:tab algn="l" pos="3651120"/>
                  <a:tab algn="l" pos="4381560"/>
                  <a:tab algn="l" pos="5111640"/>
                  <a:tab algn="l" pos="5842080"/>
                  <a:tab algn="l" pos="6572160"/>
                  <a:tab algn="l" pos="7302600"/>
                  <a:tab algn="l" pos="8032680"/>
                  <a:tab algn="l" pos="8763120"/>
                  <a:tab algn="l" pos="9493200"/>
                  <a:tab algn="l" pos="10223640"/>
                  <a:tab algn="l" pos="10953720"/>
                </a:tabLst>
              </a:pPr>
              <a:r>
                <a:rPr b="0" lang="it-IT" sz="1400" spc="-1" strike="noStrike">
                  <a:solidFill>
                    <a:srgbClr val="000000"/>
                  </a:solidFill>
                  <a:latin typeface="Arial"/>
                  <a:ea typeface="Arial"/>
                </a:rPr>
                <a:t>-6</a:t>
              </a:r>
              <a:endParaRPr b="0" lang="en-US" sz="1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2" name="CasellaDiTesto 81"/>
            <p:cNvSpPr/>
            <p:nvPr/>
          </p:nvSpPr>
          <p:spPr>
            <a:xfrm>
              <a:off x="11811240" y="4868640"/>
              <a:ext cx="339120" cy="30708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730080"/>
                  <a:tab algn="l" pos="1460520"/>
                  <a:tab algn="l" pos="2190600"/>
                  <a:tab algn="l" pos="2921040"/>
                  <a:tab algn="l" pos="3651120"/>
                  <a:tab algn="l" pos="4381560"/>
                  <a:tab algn="l" pos="5111640"/>
                  <a:tab algn="l" pos="5842080"/>
                  <a:tab algn="l" pos="6572160"/>
                  <a:tab algn="l" pos="7302600"/>
                  <a:tab algn="l" pos="8032680"/>
                  <a:tab algn="l" pos="8763120"/>
                  <a:tab algn="l" pos="9493200"/>
                  <a:tab algn="l" pos="10223640"/>
                  <a:tab algn="l" pos="10953720"/>
                </a:tabLst>
              </a:pPr>
              <a:r>
                <a:rPr b="0" lang="it-IT" sz="1400" spc="-1" strike="noStrike">
                  <a:solidFill>
                    <a:srgbClr val="000000"/>
                  </a:solidFill>
                  <a:latin typeface="Arial"/>
                  <a:ea typeface="Arial"/>
                </a:rPr>
                <a:t>-5</a:t>
              </a:r>
              <a:endParaRPr b="0" lang="en-US" sz="1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pic>
          <p:nvPicPr>
            <p:cNvPr id="83" name="Chart 2" descr=""/>
            <p:cNvPicPr/>
            <p:nvPr/>
          </p:nvPicPr>
          <p:blipFill>
            <a:blip r:embed="rId5"/>
            <a:stretch/>
          </p:blipFill>
          <p:spPr>
            <a:xfrm>
              <a:off x="4903920" y="1597320"/>
              <a:ext cx="3375000" cy="349884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84" name="CasellaDiTesto 18"/>
            <p:cNvSpPr/>
            <p:nvPr/>
          </p:nvSpPr>
          <p:spPr>
            <a:xfrm rot="16200000">
              <a:off x="3284280" y="3045240"/>
              <a:ext cx="2876040" cy="5202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730080"/>
                  <a:tab algn="l" pos="1460520"/>
                  <a:tab algn="l" pos="2190600"/>
                  <a:tab algn="l" pos="2921040"/>
                  <a:tab algn="l" pos="3651120"/>
                  <a:tab algn="l" pos="4381560"/>
                  <a:tab algn="l" pos="5111640"/>
                  <a:tab algn="l" pos="5842080"/>
                  <a:tab algn="l" pos="6572160"/>
                  <a:tab algn="l" pos="7302600"/>
                  <a:tab algn="l" pos="8032680"/>
                  <a:tab algn="l" pos="8763120"/>
                  <a:tab algn="l" pos="9493200"/>
                  <a:tab algn="l" pos="10223640"/>
                  <a:tab algn="l" pos="10953720"/>
                </a:tabLst>
              </a:pPr>
              <a:r>
                <a:rPr b="0" lang="it-IT" sz="1400" spc="-1" strike="noStrike">
                  <a:solidFill>
                    <a:srgbClr val="000000"/>
                  </a:solidFill>
                  <a:latin typeface="Arial"/>
                  <a:ea typeface="Arial"/>
                </a:rPr>
                <a:t>MTT activity/cell  (% of  untreated)</a:t>
              </a:r>
              <a:endParaRPr b="0" lang="en-US" sz="1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5" name="Straight Connector 81"/>
            <p:cNvSpPr/>
            <p:nvPr/>
          </p:nvSpPr>
          <p:spPr>
            <a:xfrm>
              <a:off x="9672120" y="4752720"/>
              <a:ext cx="58320" cy="0"/>
            </a:xfrm>
            <a:prstGeom prst="line">
              <a:avLst/>
            </a:prstGeom>
            <a:ln w="5724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9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6" name="Line 94"/>
            <p:cNvSpPr/>
            <p:nvPr/>
          </p:nvSpPr>
          <p:spPr>
            <a:xfrm flipH="1">
              <a:off x="9639720" y="4708800"/>
              <a:ext cx="55440" cy="11808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endParaRPr b="0" lang="en-US" sz="29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7" name="Line 95"/>
            <p:cNvSpPr/>
            <p:nvPr/>
          </p:nvSpPr>
          <p:spPr>
            <a:xfrm flipH="1">
              <a:off x="9698040" y="4708800"/>
              <a:ext cx="55440" cy="11808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endParaRPr b="0" lang="en-US" sz="29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8" name="Straight Connector 81"/>
            <p:cNvSpPr/>
            <p:nvPr/>
          </p:nvSpPr>
          <p:spPr>
            <a:xfrm>
              <a:off x="9672120" y="3710520"/>
              <a:ext cx="58320" cy="0"/>
            </a:xfrm>
            <a:prstGeom prst="line">
              <a:avLst/>
            </a:prstGeom>
            <a:ln w="5724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9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9" name="Line 94"/>
            <p:cNvSpPr/>
            <p:nvPr/>
          </p:nvSpPr>
          <p:spPr>
            <a:xfrm flipH="1">
              <a:off x="9639720" y="3666600"/>
              <a:ext cx="55440" cy="11808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endParaRPr b="0" lang="en-US" sz="29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0" name="Line 95"/>
            <p:cNvSpPr/>
            <p:nvPr/>
          </p:nvSpPr>
          <p:spPr>
            <a:xfrm flipH="1">
              <a:off x="9698040" y="3666600"/>
              <a:ext cx="55440" cy="11808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endParaRPr b="0" lang="en-US" sz="29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1" name="Straight Connector 81"/>
            <p:cNvSpPr/>
            <p:nvPr/>
          </p:nvSpPr>
          <p:spPr>
            <a:xfrm>
              <a:off x="9672120" y="2391480"/>
              <a:ext cx="58320" cy="0"/>
            </a:xfrm>
            <a:prstGeom prst="line">
              <a:avLst/>
            </a:prstGeom>
            <a:ln w="5724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9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2" name="Line 94"/>
            <p:cNvSpPr/>
            <p:nvPr/>
          </p:nvSpPr>
          <p:spPr>
            <a:xfrm flipH="1">
              <a:off x="9639720" y="2347560"/>
              <a:ext cx="55440" cy="11808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endParaRPr b="0" lang="en-US" sz="29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3" name="Line 95"/>
            <p:cNvSpPr/>
            <p:nvPr/>
          </p:nvSpPr>
          <p:spPr>
            <a:xfrm flipH="1">
              <a:off x="9698040" y="2347560"/>
              <a:ext cx="55440" cy="11808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endParaRPr b="0" lang="en-US" sz="29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4" name="Straight Connector 81"/>
            <p:cNvSpPr/>
            <p:nvPr/>
          </p:nvSpPr>
          <p:spPr>
            <a:xfrm>
              <a:off x="2320200" y="10855800"/>
              <a:ext cx="58320" cy="0"/>
            </a:xfrm>
            <a:prstGeom prst="line">
              <a:avLst/>
            </a:prstGeom>
            <a:ln w="5724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9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5" name="Line 94"/>
            <p:cNvSpPr/>
            <p:nvPr/>
          </p:nvSpPr>
          <p:spPr>
            <a:xfrm flipH="1">
              <a:off x="2287800" y="10811880"/>
              <a:ext cx="55440" cy="11808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endParaRPr b="0" lang="en-US" sz="29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6" name="Line 95"/>
            <p:cNvSpPr/>
            <p:nvPr/>
          </p:nvSpPr>
          <p:spPr>
            <a:xfrm flipH="1">
              <a:off x="2346120" y="10811880"/>
              <a:ext cx="55440" cy="11808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endParaRPr b="0" lang="en-US" sz="29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7" name="Straight Connector 81"/>
            <p:cNvSpPr/>
            <p:nvPr/>
          </p:nvSpPr>
          <p:spPr>
            <a:xfrm>
              <a:off x="2316960" y="10512360"/>
              <a:ext cx="58320" cy="0"/>
            </a:xfrm>
            <a:prstGeom prst="line">
              <a:avLst/>
            </a:prstGeom>
            <a:ln w="5724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9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8" name="Line 94"/>
            <p:cNvSpPr/>
            <p:nvPr/>
          </p:nvSpPr>
          <p:spPr>
            <a:xfrm flipH="1">
              <a:off x="2287800" y="10468440"/>
              <a:ext cx="55440" cy="11808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endParaRPr b="0" lang="en-US" sz="29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9" name="Line 95"/>
            <p:cNvSpPr/>
            <p:nvPr/>
          </p:nvSpPr>
          <p:spPr>
            <a:xfrm flipH="1">
              <a:off x="2346120" y="10468440"/>
              <a:ext cx="55440" cy="11808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endParaRPr b="0" lang="en-US" sz="29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0" name="Straight Connector 81"/>
            <p:cNvSpPr/>
            <p:nvPr/>
          </p:nvSpPr>
          <p:spPr>
            <a:xfrm>
              <a:off x="2312280" y="8668800"/>
              <a:ext cx="58320" cy="0"/>
            </a:xfrm>
            <a:prstGeom prst="line">
              <a:avLst/>
            </a:prstGeom>
            <a:ln w="7632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9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1" name="Line 94"/>
            <p:cNvSpPr/>
            <p:nvPr/>
          </p:nvSpPr>
          <p:spPr>
            <a:xfrm flipH="1">
              <a:off x="2287800" y="8616960"/>
              <a:ext cx="55440" cy="11808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endParaRPr b="0" lang="en-US" sz="29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2" name="Line 95"/>
            <p:cNvSpPr/>
            <p:nvPr/>
          </p:nvSpPr>
          <p:spPr>
            <a:xfrm flipH="1">
              <a:off x="2346120" y="8616960"/>
              <a:ext cx="55440" cy="11808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endParaRPr b="0" lang="en-US" sz="29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3" name="Straight Connector 81"/>
            <p:cNvSpPr/>
            <p:nvPr/>
          </p:nvSpPr>
          <p:spPr>
            <a:xfrm>
              <a:off x="2320200" y="7854840"/>
              <a:ext cx="58320" cy="0"/>
            </a:xfrm>
            <a:prstGeom prst="line">
              <a:avLst/>
            </a:prstGeom>
            <a:ln w="5724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9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4" name="Line 94"/>
            <p:cNvSpPr/>
            <p:nvPr/>
          </p:nvSpPr>
          <p:spPr>
            <a:xfrm flipH="1">
              <a:off x="2287800" y="7810920"/>
              <a:ext cx="55440" cy="11808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endParaRPr b="0" lang="en-US" sz="29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5" name="Line 95"/>
            <p:cNvSpPr/>
            <p:nvPr/>
          </p:nvSpPr>
          <p:spPr>
            <a:xfrm flipH="1">
              <a:off x="2346120" y="7810920"/>
              <a:ext cx="55440" cy="11808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endParaRPr b="0" lang="en-US" sz="29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6" name="Straight Connector 81"/>
            <p:cNvSpPr/>
            <p:nvPr/>
          </p:nvSpPr>
          <p:spPr>
            <a:xfrm>
              <a:off x="2320200" y="7679880"/>
              <a:ext cx="58320" cy="0"/>
            </a:xfrm>
            <a:prstGeom prst="line">
              <a:avLst/>
            </a:prstGeom>
            <a:ln w="5724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9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7" name="Line 94"/>
            <p:cNvSpPr/>
            <p:nvPr/>
          </p:nvSpPr>
          <p:spPr>
            <a:xfrm flipH="1">
              <a:off x="2287800" y="7635960"/>
              <a:ext cx="55440" cy="11808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endParaRPr b="0" lang="en-US" sz="29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8" name="Line 95"/>
            <p:cNvSpPr/>
            <p:nvPr/>
          </p:nvSpPr>
          <p:spPr>
            <a:xfrm flipH="1">
              <a:off x="2346120" y="7635960"/>
              <a:ext cx="55440" cy="11808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endParaRPr b="0" lang="en-US" sz="29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9" name="CasellaDiTesto 18"/>
            <p:cNvSpPr/>
            <p:nvPr/>
          </p:nvSpPr>
          <p:spPr>
            <a:xfrm rot="16200000">
              <a:off x="-83160" y="3183480"/>
              <a:ext cx="244908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730080"/>
                  <a:tab algn="l" pos="1460520"/>
                  <a:tab algn="l" pos="2190600"/>
                  <a:tab algn="l" pos="2921040"/>
                  <a:tab algn="l" pos="3651120"/>
                  <a:tab algn="l" pos="4381560"/>
                  <a:tab algn="l" pos="5111640"/>
                  <a:tab algn="l" pos="5842080"/>
                  <a:tab algn="l" pos="6572160"/>
                  <a:tab algn="l" pos="7302600"/>
                  <a:tab algn="l" pos="8032680"/>
                  <a:tab algn="l" pos="8763120"/>
                  <a:tab algn="l" pos="9493200"/>
                  <a:tab algn="l" pos="10223640"/>
                  <a:tab algn="l" pos="10953720"/>
                </a:tabLst>
              </a:pPr>
              <a:r>
                <a:rPr b="0" lang="it-IT" sz="1400" spc="-1" strike="noStrike">
                  <a:solidFill>
                    <a:srgbClr val="000000"/>
                  </a:solidFill>
                  <a:latin typeface="Arial"/>
                  <a:ea typeface="Arial"/>
                </a:rPr>
                <a:t>Cell density (% of untreated)</a:t>
              </a:r>
              <a:endParaRPr b="0" lang="en-US" sz="1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pic>
          <p:nvPicPr>
            <p:cNvPr id="110" name="Grafico 3" descr=""/>
            <p:cNvPicPr/>
            <p:nvPr/>
          </p:nvPicPr>
          <p:blipFill>
            <a:blip r:embed="rId6"/>
            <a:stretch/>
          </p:blipFill>
          <p:spPr>
            <a:xfrm>
              <a:off x="1479960" y="1682640"/>
              <a:ext cx="2643840" cy="342576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111" name="CasellaDiTesto 98"/>
            <p:cNvSpPr/>
            <p:nvPr/>
          </p:nvSpPr>
          <p:spPr>
            <a:xfrm>
              <a:off x="3142440" y="4868640"/>
              <a:ext cx="916920" cy="30708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730080"/>
                  <a:tab algn="l" pos="1460520"/>
                  <a:tab algn="l" pos="2190600"/>
                  <a:tab algn="l" pos="2921040"/>
                  <a:tab algn="l" pos="3651120"/>
                  <a:tab algn="l" pos="4381560"/>
                  <a:tab algn="l" pos="5111640"/>
                  <a:tab algn="l" pos="5842080"/>
                  <a:tab algn="l" pos="6572160"/>
                  <a:tab algn="l" pos="7302600"/>
                  <a:tab algn="l" pos="8032680"/>
                  <a:tab algn="l" pos="8763120"/>
                  <a:tab algn="l" pos="9493200"/>
                  <a:tab algn="l" pos="10223640"/>
                  <a:tab algn="l" pos="10953720"/>
                </a:tabLst>
              </a:pPr>
              <a:r>
                <a:rPr b="0" lang="it-IT" sz="1400" spc="-1" strike="noStrike">
                  <a:solidFill>
                    <a:srgbClr val="000000"/>
                  </a:solidFill>
                  <a:latin typeface="Arial"/>
                  <a:ea typeface="Arial"/>
                </a:rPr>
                <a:t>5</a:t>
              </a:r>
              <a:r>
                <a:rPr b="0" lang="it-IT" sz="1400" spc="-1" strike="noStrike">
                  <a:solidFill>
                    <a:srgbClr val="000000"/>
                  </a:solidFill>
                  <a:latin typeface="Symbol"/>
                  <a:ea typeface="Symbol"/>
                </a:rPr>
                <a:t></a:t>
              </a:r>
              <a:r>
                <a:rPr b="0" lang="it-IT" sz="1400" spc="-1" strike="noStrike">
                  <a:solidFill>
                    <a:srgbClr val="000000"/>
                  </a:solidFill>
                  <a:latin typeface="Arial"/>
                  <a:ea typeface="Arial"/>
                </a:rPr>
                <a:t>M S1P</a:t>
              </a:r>
              <a:endParaRPr b="0" lang="en-US" sz="1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2" name="CasellaDiTesto 98"/>
            <p:cNvSpPr/>
            <p:nvPr/>
          </p:nvSpPr>
          <p:spPr>
            <a:xfrm>
              <a:off x="7130520" y="4868640"/>
              <a:ext cx="916920" cy="30708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730080"/>
                  <a:tab algn="l" pos="1460520"/>
                  <a:tab algn="l" pos="2190600"/>
                  <a:tab algn="l" pos="2921040"/>
                  <a:tab algn="l" pos="3651120"/>
                  <a:tab algn="l" pos="4381560"/>
                  <a:tab algn="l" pos="5111640"/>
                  <a:tab algn="l" pos="5842080"/>
                  <a:tab algn="l" pos="6572160"/>
                  <a:tab algn="l" pos="7302600"/>
                  <a:tab algn="l" pos="8032680"/>
                  <a:tab algn="l" pos="8763120"/>
                  <a:tab algn="l" pos="9493200"/>
                  <a:tab algn="l" pos="10223640"/>
                  <a:tab algn="l" pos="10953720"/>
                </a:tabLst>
              </a:pPr>
              <a:r>
                <a:rPr b="0" lang="it-IT" sz="1400" spc="-1" strike="noStrike">
                  <a:solidFill>
                    <a:srgbClr val="000000"/>
                  </a:solidFill>
                  <a:latin typeface="Arial"/>
                  <a:ea typeface="Arial"/>
                </a:rPr>
                <a:t>5</a:t>
              </a:r>
              <a:r>
                <a:rPr b="0" lang="it-IT" sz="1400" spc="-1" strike="noStrike">
                  <a:solidFill>
                    <a:srgbClr val="000000"/>
                  </a:solidFill>
                  <a:latin typeface="Symbol"/>
                  <a:ea typeface="Symbol"/>
                </a:rPr>
                <a:t></a:t>
              </a:r>
              <a:r>
                <a:rPr b="0" lang="it-IT" sz="1400" spc="-1" strike="noStrike">
                  <a:solidFill>
                    <a:srgbClr val="000000"/>
                  </a:solidFill>
                  <a:latin typeface="Arial"/>
                  <a:ea typeface="Arial"/>
                </a:rPr>
                <a:t>M S1P</a:t>
              </a:r>
              <a:endParaRPr b="0" lang="en-US" sz="1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3" name="TextBox 69"/>
            <p:cNvSpPr/>
            <p:nvPr/>
          </p:nvSpPr>
          <p:spPr>
            <a:xfrm>
              <a:off x="4458240" y="1396440"/>
              <a:ext cx="30888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730080"/>
                  <a:tab algn="l" pos="1460520"/>
                  <a:tab algn="l" pos="2190600"/>
                  <a:tab algn="l" pos="2921040"/>
                  <a:tab algn="l" pos="3651120"/>
                  <a:tab algn="l" pos="4381560"/>
                  <a:tab algn="l" pos="5111640"/>
                  <a:tab algn="l" pos="5842080"/>
                  <a:tab algn="l" pos="6572160"/>
                  <a:tab algn="l" pos="7302600"/>
                  <a:tab algn="l" pos="8032680"/>
                  <a:tab algn="l" pos="8763120"/>
                  <a:tab algn="l" pos="9493200"/>
                  <a:tab algn="l" pos="10223640"/>
                  <a:tab algn="l" pos="1095372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Arial"/>
                  <a:ea typeface="Arial"/>
                </a:rPr>
                <a:t>B</a:t>
              </a:r>
              <a:endParaRPr b="0" lang="en-US" sz="1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4" name="TextBox 69"/>
            <p:cNvSpPr/>
            <p:nvPr/>
          </p:nvSpPr>
          <p:spPr>
            <a:xfrm>
              <a:off x="6799680" y="1722600"/>
              <a:ext cx="1208160" cy="30708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730080"/>
                  <a:tab algn="l" pos="1460520"/>
                  <a:tab algn="l" pos="2190600"/>
                  <a:tab algn="l" pos="2921040"/>
                  <a:tab algn="l" pos="3651120"/>
                  <a:tab algn="l" pos="4381560"/>
                  <a:tab algn="l" pos="5111640"/>
                  <a:tab algn="l" pos="5842080"/>
                  <a:tab algn="l" pos="6572160"/>
                  <a:tab algn="l" pos="7302600"/>
                  <a:tab algn="l" pos="8032680"/>
                  <a:tab algn="l" pos="8763120"/>
                  <a:tab algn="l" pos="9493200"/>
                  <a:tab algn="l" pos="10223640"/>
                  <a:tab algn="l" pos="1095372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  <a:ea typeface="Arial"/>
                </a:rPr>
                <a:t>IBMX</a:t>
              </a:r>
              <a:endParaRPr b="0" lang="en-US" sz="1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5" name="TextBox 69"/>
            <p:cNvSpPr/>
            <p:nvPr/>
          </p:nvSpPr>
          <p:spPr>
            <a:xfrm>
              <a:off x="8483760" y="1396440"/>
              <a:ext cx="30888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730080"/>
                  <a:tab algn="l" pos="1460520"/>
                  <a:tab algn="l" pos="2190600"/>
                  <a:tab algn="l" pos="2921040"/>
                  <a:tab algn="l" pos="3651120"/>
                  <a:tab algn="l" pos="4381560"/>
                  <a:tab algn="l" pos="5111640"/>
                  <a:tab algn="l" pos="5842080"/>
                  <a:tab algn="l" pos="6572160"/>
                  <a:tab algn="l" pos="7302600"/>
                  <a:tab algn="l" pos="8032680"/>
                  <a:tab algn="l" pos="8763120"/>
                  <a:tab algn="l" pos="9493200"/>
                  <a:tab algn="l" pos="10223640"/>
                  <a:tab algn="l" pos="1095372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Arial"/>
                  <a:ea typeface="Arial"/>
                </a:rPr>
                <a:t>C</a:t>
              </a:r>
              <a:endParaRPr b="0" lang="en-US" sz="1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6" name="TextBox 60"/>
            <p:cNvSpPr/>
            <p:nvPr/>
          </p:nvSpPr>
          <p:spPr>
            <a:xfrm>
              <a:off x="6973920" y="6698160"/>
              <a:ext cx="28908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730080"/>
                  <a:tab algn="l" pos="1460520"/>
                  <a:tab algn="l" pos="2190600"/>
                  <a:tab algn="l" pos="2921040"/>
                  <a:tab algn="l" pos="3651120"/>
                  <a:tab algn="l" pos="4381560"/>
                  <a:tab algn="l" pos="5111640"/>
                  <a:tab algn="l" pos="5842080"/>
                  <a:tab algn="l" pos="6572160"/>
                  <a:tab algn="l" pos="7302600"/>
                  <a:tab algn="l" pos="8032680"/>
                  <a:tab algn="l" pos="8763120"/>
                  <a:tab algn="l" pos="9493200"/>
                  <a:tab algn="l" pos="10223640"/>
                  <a:tab algn="l" pos="1095372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Arial"/>
                  <a:ea typeface="Arial"/>
                </a:rPr>
                <a:t>F</a:t>
              </a:r>
              <a:endParaRPr b="0" lang="en-US" sz="1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7" name="Rettangolo 8"/>
            <p:cNvSpPr/>
            <p:nvPr/>
          </p:nvSpPr>
          <p:spPr>
            <a:xfrm>
              <a:off x="2147400" y="1866960"/>
              <a:ext cx="96840" cy="96840"/>
            </a:xfrm>
            <a:prstGeom prst="rect">
              <a:avLst/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730080"/>
                  <a:tab algn="l" pos="1460520"/>
                  <a:tab algn="l" pos="2190600"/>
                  <a:tab algn="l" pos="2921040"/>
                  <a:tab algn="l" pos="3651120"/>
                  <a:tab algn="l" pos="4381560"/>
                  <a:tab algn="l" pos="5111640"/>
                  <a:tab algn="l" pos="5842080"/>
                  <a:tab algn="l" pos="6572160"/>
                  <a:tab algn="l" pos="7302600"/>
                  <a:tab algn="l" pos="8032680"/>
                  <a:tab algn="l" pos="8763120"/>
                  <a:tab algn="l" pos="9493200"/>
                  <a:tab algn="l" pos="10223640"/>
                  <a:tab algn="l" pos="10953720"/>
                </a:tabLst>
              </a:pPr>
              <a:endParaRPr b="0" lang="en-US" sz="29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8" name="Rettangolo 88"/>
            <p:cNvSpPr/>
            <p:nvPr/>
          </p:nvSpPr>
          <p:spPr>
            <a:xfrm>
              <a:off x="2146320" y="2125080"/>
              <a:ext cx="96840" cy="96840"/>
            </a:xfrm>
            <a:prstGeom prst="rect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730080"/>
                  <a:tab algn="l" pos="1460520"/>
                  <a:tab algn="l" pos="2190600"/>
                  <a:tab algn="l" pos="2921040"/>
                  <a:tab algn="l" pos="3651120"/>
                  <a:tab algn="l" pos="4381560"/>
                  <a:tab algn="l" pos="5111640"/>
                  <a:tab algn="l" pos="5842080"/>
                  <a:tab algn="l" pos="6572160"/>
                  <a:tab algn="l" pos="7302600"/>
                  <a:tab algn="l" pos="8032680"/>
                  <a:tab algn="l" pos="8763120"/>
                  <a:tab algn="l" pos="9493200"/>
                  <a:tab algn="l" pos="10223640"/>
                  <a:tab algn="l" pos="10953720"/>
                </a:tabLst>
              </a:pPr>
              <a:endParaRPr b="0" lang="en-US" sz="29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9" name="CasellaDiTesto 9"/>
            <p:cNvSpPr/>
            <p:nvPr/>
          </p:nvSpPr>
          <p:spPr>
            <a:xfrm>
              <a:off x="2283120" y="1743120"/>
              <a:ext cx="114084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730080"/>
                  <a:tab algn="l" pos="1460520"/>
                  <a:tab algn="l" pos="2190600"/>
                  <a:tab algn="l" pos="2921040"/>
                  <a:tab algn="l" pos="3651120"/>
                  <a:tab algn="l" pos="4381560"/>
                  <a:tab algn="l" pos="5111640"/>
                  <a:tab algn="l" pos="5842080"/>
                  <a:tab algn="l" pos="6572160"/>
                  <a:tab algn="l" pos="7302600"/>
                  <a:tab algn="l" pos="8032680"/>
                  <a:tab algn="l" pos="8763120"/>
                  <a:tab algn="l" pos="9493200"/>
                  <a:tab algn="l" pos="10223640"/>
                  <a:tab algn="l" pos="10953720"/>
                </a:tabLst>
              </a:pPr>
              <a:r>
                <a:rPr b="0" lang="it-IT" sz="1400" spc="-1" strike="noStrike">
                  <a:solidFill>
                    <a:srgbClr val="000000"/>
                  </a:solidFill>
                  <a:latin typeface="Arial"/>
                  <a:ea typeface="Arial"/>
                </a:rPr>
                <a:t>regular FCS</a:t>
              </a:r>
              <a:endParaRPr b="0" lang="en-US" sz="1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0" name="CasellaDiTesto 98"/>
            <p:cNvSpPr/>
            <p:nvPr/>
          </p:nvSpPr>
          <p:spPr>
            <a:xfrm>
              <a:off x="8789040" y="4868640"/>
              <a:ext cx="1122480" cy="30708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730080"/>
                  <a:tab algn="l" pos="1460520"/>
                  <a:tab algn="l" pos="2190600"/>
                  <a:tab algn="l" pos="2921040"/>
                  <a:tab algn="l" pos="3651120"/>
                  <a:tab algn="l" pos="4381560"/>
                  <a:tab algn="l" pos="5111640"/>
                  <a:tab algn="l" pos="5842080"/>
                  <a:tab algn="l" pos="6572160"/>
                  <a:tab algn="l" pos="7302600"/>
                  <a:tab algn="l" pos="8032680"/>
                  <a:tab algn="l" pos="8763120"/>
                  <a:tab algn="l" pos="9493200"/>
                  <a:tab algn="l" pos="10223640"/>
                  <a:tab algn="l" pos="10953720"/>
                </a:tabLst>
              </a:pPr>
              <a:r>
                <a:rPr b="0" lang="it-IT" sz="1400" spc="-1" strike="noStrike">
                  <a:solidFill>
                    <a:srgbClr val="000000"/>
                  </a:solidFill>
                  <a:latin typeface="Arial"/>
                  <a:ea typeface="Arial"/>
                </a:rPr>
                <a:t>S1P (log M)</a:t>
              </a:r>
              <a:endParaRPr b="0" lang="en-US" sz="1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1" name="CasellaDiTesto 89"/>
            <p:cNvSpPr/>
            <p:nvPr/>
          </p:nvSpPr>
          <p:spPr>
            <a:xfrm>
              <a:off x="2270520" y="1998000"/>
              <a:ext cx="1550880" cy="5202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730080"/>
                  <a:tab algn="l" pos="1460520"/>
                  <a:tab algn="l" pos="2190600"/>
                  <a:tab algn="l" pos="2921040"/>
                  <a:tab algn="l" pos="3651120"/>
                  <a:tab algn="l" pos="4381560"/>
                  <a:tab algn="l" pos="5111640"/>
                  <a:tab algn="l" pos="5842080"/>
                  <a:tab algn="l" pos="6572160"/>
                  <a:tab algn="l" pos="7302600"/>
                  <a:tab algn="l" pos="8032680"/>
                  <a:tab algn="l" pos="8763120"/>
                  <a:tab algn="l" pos="9493200"/>
                  <a:tab algn="l" pos="10223640"/>
                  <a:tab algn="l" pos="10953720"/>
                </a:tabLst>
              </a:pPr>
              <a:r>
                <a:rPr b="0" lang="it-IT" sz="1400" spc="-1" strike="noStrike">
                  <a:solidFill>
                    <a:srgbClr val="000000"/>
                  </a:solidFill>
                  <a:latin typeface="Arial"/>
                  <a:ea typeface="Arial"/>
                </a:rPr>
                <a:t>charcoal-stripped</a:t>
              </a:r>
              <a:endParaRPr b="0" lang="en-US" sz="14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730080"/>
                  <a:tab algn="l" pos="1460520"/>
                  <a:tab algn="l" pos="2190600"/>
                  <a:tab algn="l" pos="2921040"/>
                  <a:tab algn="l" pos="3651120"/>
                  <a:tab algn="l" pos="4381560"/>
                  <a:tab algn="l" pos="5111640"/>
                  <a:tab algn="l" pos="5842080"/>
                  <a:tab algn="l" pos="6572160"/>
                  <a:tab algn="l" pos="7302600"/>
                  <a:tab algn="l" pos="8032680"/>
                  <a:tab algn="l" pos="8763120"/>
                  <a:tab algn="l" pos="9493200"/>
                  <a:tab algn="l" pos="10223640"/>
                  <a:tab algn="l" pos="10953720"/>
                </a:tabLst>
              </a:pPr>
              <a:r>
                <a:rPr b="0" lang="it-IT" sz="1400" spc="-1" strike="noStrike">
                  <a:solidFill>
                    <a:srgbClr val="000000"/>
                  </a:solidFill>
                  <a:latin typeface="Arial"/>
                  <a:ea typeface="Arial"/>
                </a:rPr>
                <a:t>FCS</a:t>
              </a:r>
              <a:endParaRPr b="0" lang="en-US" sz="1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2" name="CasellaDiTesto 98"/>
            <p:cNvSpPr/>
            <p:nvPr/>
          </p:nvSpPr>
          <p:spPr>
            <a:xfrm>
              <a:off x="2430360" y="4868640"/>
              <a:ext cx="240120" cy="30708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730080"/>
                  <a:tab algn="l" pos="1460520"/>
                  <a:tab algn="l" pos="2190600"/>
                  <a:tab algn="l" pos="2921040"/>
                  <a:tab algn="l" pos="3651120"/>
                  <a:tab algn="l" pos="4381560"/>
                  <a:tab algn="l" pos="5111640"/>
                  <a:tab algn="l" pos="5842080"/>
                  <a:tab algn="l" pos="6572160"/>
                  <a:tab algn="l" pos="7302600"/>
                  <a:tab algn="l" pos="8032680"/>
                  <a:tab algn="l" pos="8763120"/>
                  <a:tab algn="l" pos="9493200"/>
                  <a:tab algn="l" pos="10223640"/>
                  <a:tab algn="l" pos="10953720"/>
                </a:tabLst>
              </a:pPr>
              <a:r>
                <a:rPr b="0" lang="it-IT" sz="1400" spc="-1" strike="noStrike">
                  <a:solidFill>
                    <a:srgbClr val="000000"/>
                  </a:solidFill>
                  <a:latin typeface="Arial"/>
                  <a:ea typeface="Arial"/>
                </a:rPr>
                <a:t>-</a:t>
              </a:r>
              <a:endParaRPr b="0" lang="en-US" sz="1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3" name="CasellaDiTesto 98"/>
            <p:cNvSpPr/>
            <p:nvPr/>
          </p:nvSpPr>
          <p:spPr>
            <a:xfrm>
              <a:off x="6102720" y="4868640"/>
              <a:ext cx="240120" cy="30708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730080"/>
                  <a:tab algn="l" pos="1460520"/>
                  <a:tab algn="l" pos="2190600"/>
                  <a:tab algn="l" pos="2921040"/>
                  <a:tab algn="l" pos="3651120"/>
                  <a:tab algn="l" pos="4381560"/>
                  <a:tab algn="l" pos="5111640"/>
                  <a:tab algn="l" pos="5842080"/>
                  <a:tab algn="l" pos="6572160"/>
                  <a:tab algn="l" pos="7302600"/>
                  <a:tab algn="l" pos="8032680"/>
                  <a:tab algn="l" pos="8763120"/>
                  <a:tab algn="l" pos="9493200"/>
                  <a:tab algn="l" pos="10223640"/>
                  <a:tab algn="l" pos="10953720"/>
                </a:tabLst>
              </a:pPr>
              <a:r>
                <a:rPr b="0" lang="it-IT" sz="1400" spc="-1" strike="noStrike">
                  <a:solidFill>
                    <a:srgbClr val="000000"/>
                  </a:solidFill>
                  <a:latin typeface="Arial"/>
                  <a:ea typeface="Arial"/>
                </a:rPr>
                <a:t>-</a:t>
              </a:r>
              <a:endParaRPr b="0" lang="en-US" sz="14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4779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5-12-23T08:48:02Z</dcterms:created>
  <dc:creator>Giulio Innamorati</dc:creator>
  <dc:description/>
  <dc:language>en-US</dc:language>
  <cp:lastModifiedBy>shanmugam.s</cp:lastModifiedBy>
  <cp:lastPrinted>2017-01-10T10:08:55Z</cp:lastPrinted>
  <dcterms:modified xsi:type="dcterms:W3CDTF">2017-07-07T14:33:55Z</dcterms:modified>
  <cp:revision>392</cp:revision>
  <dc:subject/>
  <dc:title>PowerPoint Presentation</dc:title>
</cp:coreProperties>
</file>